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5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 smtClean="0"/>
              <a:t>15-19</a:t>
            </a:r>
            <a:r>
              <a:rPr lang="en-US" baseline="0" dirty="0" smtClean="0"/>
              <a:t> years old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8.7473392710982284E-2"/>
          <c:y val="0.1018241469816273"/>
          <c:w val="0.89320434268031346"/>
          <c:h val="0.74557830271216097"/>
        </c:manualLayout>
      </c:layou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The number of influenza cases per week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C$2:$C$314</c:f>
              <c:numCache>
                <c:formatCode>General</c:formatCode>
                <c:ptCount val="313"/>
                <c:pt idx="0">
                  <c:v>58</c:v>
                </c:pt>
                <c:pt idx="1">
                  <c:v>105</c:v>
                </c:pt>
                <c:pt idx="2">
                  <c:v>232</c:v>
                </c:pt>
                <c:pt idx="3">
                  <c:v>297</c:v>
                </c:pt>
                <c:pt idx="4">
                  <c:v>331</c:v>
                </c:pt>
                <c:pt idx="5">
                  <c:v>303</c:v>
                </c:pt>
                <c:pt idx="6">
                  <c:v>172</c:v>
                </c:pt>
                <c:pt idx="7">
                  <c:v>163</c:v>
                </c:pt>
                <c:pt idx="8">
                  <c:v>109</c:v>
                </c:pt>
                <c:pt idx="9">
                  <c:v>96</c:v>
                </c:pt>
                <c:pt idx="10">
                  <c:v>81</c:v>
                </c:pt>
                <c:pt idx="11">
                  <c:v>96</c:v>
                </c:pt>
                <c:pt idx="12">
                  <c:v>57</c:v>
                </c:pt>
                <c:pt idx="13">
                  <c:v>48</c:v>
                </c:pt>
                <c:pt idx="14">
                  <c:v>38</c:v>
                </c:pt>
                <c:pt idx="15">
                  <c:v>55</c:v>
                </c:pt>
                <c:pt idx="16">
                  <c:v>31</c:v>
                </c:pt>
                <c:pt idx="17">
                  <c:v>7</c:v>
                </c:pt>
                <c:pt idx="18">
                  <c:v>6</c:v>
                </c:pt>
                <c:pt idx="19">
                  <c:v>3</c:v>
                </c:pt>
                <c:pt idx="20">
                  <c:v>7</c:v>
                </c:pt>
                <c:pt idx="21">
                  <c:v>2</c:v>
                </c:pt>
                <c:pt idx="22">
                  <c:v>0</c:v>
                </c:pt>
                <c:pt idx="23">
                  <c:v>0</c:v>
                </c:pt>
                <c:pt idx="24">
                  <c:v>1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1</c:v>
                </c:pt>
                <c:pt idx="30">
                  <c:v>0</c:v>
                </c:pt>
                <c:pt idx="31">
                  <c:v>0</c:v>
                </c:pt>
                <c:pt idx="32">
                  <c:v>1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1</c:v>
                </c:pt>
                <c:pt idx="38">
                  <c:v>0</c:v>
                </c:pt>
                <c:pt idx="39">
                  <c:v>1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1</c:v>
                </c:pt>
                <c:pt idx="45">
                  <c:v>0</c:v>
                </c:pt>
                <c:pt idx="46">
                  <c:v>3</c:v>
                </c:pt>
                <c:pt idx="47">
                  <c:v>1</c:v>
                </c:pt>
                <c:pt idx="48">
                  <c:v>1</c:v>
                </c:pt>
                <c:pt idx="49">
                  <c:v>4</c:v>
                </c:pt>
                <c:pt idx="50">
                  <c:v>3</c:v>
                </c:pt>
                <c:pt idx="51">
                  <c:v>7</c:v>
                </c:pt>
                <c:pt idx="52">
                  <c:v>27</c:v>
                </c:pt>
                <c:pt idx="53">
                  <c:v>109</c:v>
                </c:pt>
                <c:pt idx="54">
                  <c:v>255</c:v>
                </c:pt>
                <c:pt idx="55">
                  <c:v>385</c:v>
                </c:pt>
                <c:pt idx="56">
                  <c:v>400</c:v>
                </c:pt>
                <c:pt idx="57">
                  <c:v>330</c:v>
                </c:pt>
                <c:pt idx="58">
                  <c:v>164</c:v>
                </c:pt>
                <c:pt idx="59">
                  <c:v>151</c:v>
                </c:pt>
                <c:pt idx="60">
                  <c:v>103</c:v>
                </c:pt>
                <c:pt idx="61">
                  <c:v>72</c:v>
                </c:pt>
                <c:pt idx="62">
                  <c:v>53</c:v>
                </c:pt>
                <c:pt idx="63">
                  <c:v>25</c:v>
                </c:pt>
                <c:pt idx="64">
                  <c:v>16</c:v>
                </c:pt>
                <c:pt idx="65">
                  <c:v>9</c:v>
                </c:pt>
                <c:pt idx="66">
                  <c:v>20</c:v>
                </c:pt>
                <c:pt idx="67">
                  <c:v>28</c:v>
                </c:pt>
                <c:pt idx="68">
                  <c:v>17</c:v>
                </c:pt>
                <c:pt idx="69">
                  <c:v>24</c:v>
                </c:pt>
                <c:pt idx="70">
                  <c:v>24</c:v>
                </c:pt>
                <c:pt idx="71">
                  <c:v>32</c:v>
                </c:pt>
                <c:pt idx="72">
                  <c:v>23</c:v>
                </c:pt>
                <c:pt idx="73">
                  <c:v>9</c:v>
                </c:pt>
                <c:pt idx="74">
                  <c:v>7</c:v>
                </c:pt>
                <c:pt idx="75">
                  <c:v>4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1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1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1</c:v>
                </c:pt>
                <c:pt idx="97">
                  <c:v>1</c:v>
                </c:pt>
                <c:pt idx="98">
                  <c:v>1</c:v>
                </c:pt>
                <c:pt idx="99">
                  <c:v>3</c:v>
                </c:pt>
                <c:pt idx="100">
                  <c:v>4</c:v>
                </c:pt>
                <c:pt idx="101">
                  <c:v>4</c:v>
                </c:pt>
                <c:pt idx="102">
                  <c:v>10</c:v>
                </c:pt>
                <c:pt idx="103">
                  <c:v>15</c:v>
                </c:pt>
                <c:pt idx="104">
                  <c:v>29</c:v>
                </c:pt>
                <c:pt idx="105">
                  <c:v>64</c:v>
                </c:pt>
                <c:pt idx="106">
                  <c:v>108</c:v>
                </c:pt>
                <c:pt idx="107">
                  <c:v>243</c:v>
                </c:pt>
                <c:pt idx="108">
                  <c:v>242</c:v>
                </c:pt>
                <c:pt idx="109">
                  <c:v>215</c:v>
                </c:pt>
                <c:pt idx="110">
                  <c:v>214</c:v>
                </c:pt>
                <c:pt idx="111">
                  <c:v>179</c:v>
                </c:pt>
                <c:pt idx="112">
                  <c:v>205</c:v>
                </c:pt>
                <c:pt idx="113">
                  <c:v>152</c:v>
                </c:pt>
                <c:pt idx="114">
                  <c:v>136</c:v>
                </c:pt>
                <c:pt idx="115">
                  <c:v>151</c:v>
                </c:pt>
                <c:pt idx="116">
                  <c:v>115</c:v>
                </c:pt>
                <c:pt idx="117">
                  <c:v>54</c:v>
                </c:pt>
                <c:pt idx="118">
                  <c:v>37</c:v>
                </c:pt>
                <c:pt idx="119">
                  <c:v>86</c:v>
                </c:pt>
                <c:pt idx="120">
                  <c:v>50</c:v>
                </c:pt>
                <c:pt idx="121">
                  <c:v>34</c:v>
                </c:pt>
                <c:pt idx="122">
                  <c:v>19</c:v>
                </c:pt>
                <c:pt idx="123">
                  <c:v>7</c:v>
                </c:pt>
                <c:pt idx="124">
                  <c:v>10</c:v>
                </c:pt>
                <c:pt idx="125">
                  <c:v>4</c:v>
                </c:pt>
                <c:pt idx="126">
                  <c:v>0</c:v>
                </c:pt>
                <c:pt idx="127">
                  <c:v>1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1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2</c:v>
                </c:pt>
                <c:pt idx="137">
                  <c:v>0</c:v>
                </c:pt>
                <c:pt idx="138">
                  <c:v>0</c:v>
                </c:pt>
                <c:pt idx="139">
                  <c:v>1</c:v>
                </c:pt>
                <c:pt idx="140">
                  <c:v>3</c:v>
                </c:pt>
                <c:pt idx="141">
                  <c:v>0</c:v>
                </c:pt>
                <c:pt idx="142">
                  <c:v>1</c:v>
                </c:pt>
                <c:pt idx="143">
                  <c:v>0</c:v>
                </c:pt>
                <c:pt idx="144">
                  <c:v>1</c:v>
                </c:pt>
                <c:pt idx="145">
                  <c:v>0</c:v>
                </c:pt>
                <c:pt idx="146">
                  <c:v>1</c:v>
                </c:pt>
                <c:pt idx="147">
                  <c:v>2</c:v>
                </c:pt>
                <c:pt idx="148">
                  <c:v>1</c:v>
                </c:pt>
                <c:pt idx="149">
                  <c:v>2</c:v>
                </c:pt>
                <c:pt idx="150">
                  <c:v>8</c:v>
                </c:pt>
                <c:pt idx="151">
                  <c:v>10</c:v>
                </c:pt>
                <c:pt idx="152">
                  <c:v>28</c:v>
                </c:pt>
                <c:pt idx="153">
                  <c:v>60</c:v>
                </c:pt>
                <c:pt idx="154">
                  <c:v>190</c:v>
                </c:pt>
                <c:pt idx="155">
                  <c:v>392</c:v>
                </c:pt>
                <c:pt idx="156">
                  <c:v>321</c:v>
                </c:pt>
                <c:pt idx="157">
                  <c:v>401</c:v>
                </c:pt>
                <c:pt idx="158">
                  <c:v>333</c:v>
                </c:pt>
                <c:pt idx="159">
                  <c:v>279</c:v>
                </c:pt>
                <c:pt idx="160">
                  <c:v>203</c:v>
                </c:pt>
                <c:pt idx="161">
                  <c:v>134</c:v>
                </c:pt>
                <c:pt idx="162">
                  <c:v>71</c:v>
                </c:pt>
                <c:pt idx="163">
                  <c:v>45</c:v>
                </c:pt>
                <c:pt idx="164">
                  <c:v>33</c:v>
                </c:pt>
                <c:pt idx="165">
                  <c:v>24</c:v>
                </c:pt>
                <c:pt idx="166">
                  <c:v>27</c:v>
                </c:pt>
                <c:pt idx="167">
                  <c:v>25</c:v>
                </c:pt>
                <c:pt idx="168">
                  <c:v>17</c:v>
                </c:pt>
                <c:pt idx="169">
                  <c:v>16</c:v>
                </c:pt>
                <c:pt idx="170">
                  <c:v>17</c:v>
                </c:pt>
                <c:pt idx="171">
                  <c:v>14</c:v>
                </c:pt>
                <c:pt idx="172">
                  <c:v>31</c:v>
                </c:pt>
                <c:pt idx="173">
                  <c:v>22</c:v>
                </c:pt>
                <c:pt idx="174">
                  <c:v>8</c:v>
                </c:pt>
                <c:pt idx="175">
                  <c:v>7</c:v>
                </c:pt>
                <c:pt idx="176">
                  <c:v>3</c:v>
                </c:pt>
                <c:pt idx="177">
                  <c:v>2</c:v>
                </c:pt>
                <c:pt idx="178">
                  <c:v>3</c:v>
                </c:pt>
                <c:pt idx="179">
                  <c:v>1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2</c:v>
                </c:pt>
                <c:pt idx="184">
                  <c:v>1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1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1</c:v>
                </c:pt>
                <c:pt idx="199">
                  <c:v>0</c:v>
                </c:pt>
                <c:pt idx="200">
                  <c:v>1</c:v>
                </c:pt>
                <c:pt idx="201">
                  <c:v>2</c:v>
                </c:pt>
                <c:pt idx="202">
                  <c:v>1</c:v>
                </c:pt>
                <c:pt idx="203">
                  <c:v>0</c:v>
                </c:pt>
                <c:pt idx="204">
                  <c:v>3</c:v>
                </c:pt>
                <c:pt idx="205">
                  <c:v>4</c:v>
                </c:pt>
                <c:pt idx="206">
                  <c:v>6</c:v>
                </c:pt>
                <c:pt idx="207">
                  <c:v>9</c:v>
                </c:pt>
                <c:pt idx="208">
                  <c:v>21</c:v>
                </c:pt>
                <c:pt idx="209">
                  <c:v>24</c:v>
                </c:pt>
                <c:pt idx="210">
                  <c:v>47</c:v>
                </c:pt>
                <c:pt idx="211">
                  <c:v>128</c:v>
                </c:pt>
                <c:pt idx="212">
                  <c:v>220</c:v>
                </c:pt>
                <c:pt idx="213">
                  <c:v>363</c:v>
                </c:pt>
                <c:pt idx="214">
                  <c:v>394</c:v>
                </c:pt>
                <c:pt idx="215">
                  <c:v>432</c:v>
                </c:pt>
                <c:pt idx="216">
                  <c:v>402</c:v>
                </c:pt>
                <c:pt idx="217">
                  <c:v>404</c:v>
                </c:pt>
                <c:pt idx="218">
                  <c:v>228</c:v>
                </c:pt>
                <c:pt idx="219">
                  <c:v>159</c:v>
                </c:pt>
                <c:pt idx="220">
                  <c:v>93</c:v>
                </c:pt>
                <c:pt idx="221">
                  <c:v>81</c:v>
                </c:pt>
                <c:pt idx="222">
                  <c:v>48</c:v>
                </c:pt>
                <c:pt idx="223">
                  <c:v>36</c:v>
                </c:pt>
                <c:pt idx="224">
                  <c:v>35</c:v>
                </c:pt>
                <c:pt idx="225">
                  <c:v>26</c:v>
                </c:pt>
                <c:pt idx="226">
                  <c:v>6</c:v>
                </c:pt>
                <c:pt idx="227">
                  <c:v>6</c:v>
                </c:pt>
                <c:pt idx="228">
                  <c:v>4</c:v>
                </c:pt>
                <c:pt idx="229">
                  <c:v>1</c:v>
                </c:pt>
                <c:pt idx="230">
                  <c:v>1</c:v>
                </c:pt>
                <c:pt idx="231">
                  <c:v>0</c:v>
                </c:pt>
                <c:pt idx="232">
                  <c:v>1</c:v>
                </c:pt>
                <c:pt idx="233">
                  <c:v>1</c:v>
                </c:pt>
                <c:pt idx="234">
                  <c:v>0</c:v>
                </c:pt>
                <c:pt idx="235">
                  <c:v>1</c:v>
                </c:pt>
                <c:pt idx="236">
                  <c:v>1</c:v>
                </c:pt>
                <c:pt idx="237">
                  <c:v>1</c:v>
                </c:pt>
                <c:pt idx="238">
                  <c:v>0</c:v>
                </c:pt>
                <c:pt idx="239">
                  <c:v>0</c:v>
                </c:pt>
                <c:pt idx="240">
                  <c:v>1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1</c:v>
                </c:pt>
                <c:pt idx="246">
                  <c:v>0</c:v>
                </c:pt>
                <c:pt idx="247">
                  <c:v>1</c:v>
                </c:pt>
                <c:pt idx="248">
                  <c:v>2</c:v>
                </c:pt>
                <c:pt idx="249">
                  <c:v>4</c:v>
                </c:pt>
                <c:pt idx="250">
                  <c:v>3</c:v>
                </c:pt>
                <c:pt idx="251">
                  <c:v>1</c:v>
                </c:pt>
                <c:pt idx="252">
                  <c:v>5</c:v>
                </c:pt>
                <c:pt idx="253">
                  <c:v>6</c:v>
                </c:pt>
                <c:pt idx="254">
                  <c:v>19</c:v>
                </c:pt>
                <c:pt idx="255">
                  <c:v>23</c:v>
                </c:pt>
                <c:pt idx="256">
                  <c:v>24</c:v>
                </c:pt>
                <c:pt idx="257">
                  <c:v>38</c:v>
                </c:pt>
                <c:pt idx="258">
                  <c:v>46</c:v>
                </c:pt>
                <c:pt idx="259">
                  <c:v>92</c:v>
                </c:pt>
                <c:pt idx="260">
                  <c:v>133</c:v>
                </c:pt>
                <c:pt idx="261">
                  <c:v>168</c:v>
                </c:pt>
                <c:pt idx="262">
                  <c:v>226</c:v>
                </c:pt>
                <c:pt idx="263">
                  <c:v>514</c:v>
                </c:pt>
                <c:pt idx="264">
                  <c:v>742</c:v>
                </c:pt>
                <c:pt idx="265">
                  <c:v>577</c:v>
                </c:pt>
                <c:pt idx="266">
                  <c:v>379</c:v>
                </c:pt>
                <c:pt idx="267">
                  <c:v>251</c:v>
                </c:pt>
                <c:pt idx="268">
                  <c:v>151</c:v>
                </c:pt>
                <c:pt idx="269">
                  <c:v>111</c:v>
                </c:pt>
                <c:pt idx="270">
                  <c:v>55</c:v>
                </c:pt>
                <c:pt idx="271">
                  <c:v>51</c:v>
                </c:pt>
                <c:pt idx="272">
                  <c:v>31</c:v>
                </c:pt>
                <c:pt idx="273">
                  <c:v>29</c:v>
                </c:pt>
                <c:pt idx="274">
                  <c:v>24</c:v>
                </c:pt>
                <c:pt idx="275">
                  <c:v>23</c:v>
                </c:pt>
                <c:pt idx="276">
                  <c:v>24</c:v>
                </c:pt>
                <c:pt idx="277">
                  <c:v>31</c:v>
                </c:pt>
                <c:pt idx="278">
                  <c:v>20</c:v>
                </c:pt>
                <c:pt idx="279">
                  <c:v>9</c:v>
                </c:pt>
                <c:pt idx="280">
                  <c:v>11</c:v>
                </c:pt>
                <c:pt idx="281">
                  <c:v>6</c:v>
                </c:pt>
                <c:pt idx="282">
                  <c:v>6</c:v>
                </c:pt>
                <c:pt idx="283">
                  <c:v>4</c:v>
                </c:pt>
                <c:pt idx="284">
                  <c:v>5</c:v>
                </c:pt>
                <c:pt idx="285">
                  <c:v>3</c:v>
                </c:pt>
                <c:pt idx="286">
                  <c:v>0</c:v>
                </c:pt>
                <c:pt idx="287">
                  <c:v>1</c:v>
                </c:pt>
                <c:pt idx="288">
                  <c:v>2</c:v>
                </c:pt>
                <c:pt idx="289">
                  <c:v>0</c:v>
                </c:pt>
                <c:pt idx="290">
                  <c:v>1</c:v>
                </c:pt>
                <c:pt idx="291">
                  <c:v>0</c:v>
                </c:pt>
                <c:pt idx="292">
                  <c:v>0</c:v>
                </c:pt>
                <c:pt idx="293">
                  <c:v>1</c:v>
                </c:pt>
                <c:pt idx="294">
                  <c:v>1</c:v>
                </c:pt>
                <c:pt idx="295">
                  <c:v>2</c:v>
                </c:pt>
                <c:pt idx="296">
                  <c:v>0</c:v>
                </c:pt>
                <c:pt idx="297">
                  <c:v>0</c:v>
                </c:pt>
                <c:pt idx="298">
                  <c:v>2</c:v>
                </c:pt>
                <c:pt idx="299">
                  <c:v>1</c:v>
                </c:pt>
                <c:pt idx="300">
                  <c:v>4</c:v>
                </c:pt>
                <c:pt idx="301">
                  <c:v>4</c:v>
                </c:pt>
                <c:pt idx="302">
                  <c:v>4</c:v>
                </c:pt>
                <c:pt idx="303">
                  <c:v>4</c:v>
                </c:pt>
                <c:pt idx="304">
                  <c:v>2</c:v>
                </c:pt>
                <c:pt idx="305">
                  <c:v>3</c:v>
                </c:pt>
                <c:pt idx="306">
                  <c:v>6</c:v>
                </c:pt>
                <c:pt idx="307">
                  <c:v>12</c:v>
                </c:pt>
                <c:pt idx="308">
                  <c:v>13</c:v>
                </c:pt>
                <c:pt idx="309">
                  <c:v>14</c:v>
                </c:pt>
                <c:pt idx="310">
                  <c:v>35</c:v>
                </c:pt>
                <c:pt idx="311">
                  <c:v>95</c:v>
                </c:pt>
                <c:pt idx="312">
                  <c:v>1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B3D-4EC0-A8D6-5E64F831BF17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The predict number of influenza patients calculated from regression model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E$2:$E$314</c:f>
              <c:numCache>
                <c:formatCode>General</c:formatCode>
                <c:ptCount val="313"/>
                <c:pt idx="0">
                  <c:v>29.516588566463142</c:v>
                </c:pt>
                <c:pt idx="1">
                  <c:v>120.2616544576963</c:v>
                </c:pt>
                <c:pt idx="2">
                  <c:v>268.98801511681438</c:v>
                </c:pt>
                <c:pt idx="3">
                  <c:v>335.39790775225725</c:v>
                </c:pt>
                <c:pt idx="4">
                  <c:v>284.99893507804222</c:v>
                </c:pt>
                <c:pt idx="5">
                  <c:v>316.28114786857259</c:v>
                </c:pt>
                <c:pt idx="6">
                  <c:v>244.77184089173298</c:v>
                </c:pt>
                <c:pt idx="7">
                  <c:v>183.66552073664624</c:v>
                </c:pt>
                <c:pt idx="8">
                  <c:v>146.20332015507128</c:v>
                </c:pt>
                <c:pt idx="9">
                  <c:v>88.042027325769652</c:v>
                </c:pt>
                <c:pt idx="10">
                  <c:v>108.27874670542306</c:v>
                </c:pt>
                <c:pt idx="11">
                  <c:v>70.169453876121537</c:v>
                </c:pt>
                <c:pt idx="12">
                  <c:v>78.107666666651426</c:v>
                </c:pt>
                <c:pt idx="13">
                  <c:v>40.483693023144831</c:v>
                </c:pt>
                <c:pt idx="14">
                  <c:v>85.20122693805331</c:v>
                </c:pt>
                <c:pt idx="15">
                  <c:v>25.704280620331652</c:v>
                </c:pt>
                <c:pt idx="16">
                  <c:v>60.265506589108249</c:v>
                </c:pt>
                <c:pt idx="17">
                  <c:v>9.6905602713866728</c:v>
                </c:pt>
                <c:pt idx="18">
                  <c:v>-13.603532945631677</c:v>
                </c:pt>
                <c:pt idx="19">
                  <c:v>-16.766266472823389</c:v>
                </c:pt>
                <c:pt idx="20">
                  <c:v>11.993000000000002</c:v>
                </c:pt>
                <c:pt idx="21">
                  <c:v>-8.8015734496634046</c:v>
                </c:pt>
                <c:pt idx="22">
                  <c:v>9.6503596898115447</c:v>
                </c:pt>
                <c:pt idx="23">
                  <c:v>-10.80157344966338</c:v>
                </c:pt>
                <c:pt idx="24">
                  <c:v>-33.915759883700041</c:v>
                </c:pt>
                <c:pt idx="25">
                  <c:v>5.4876261626198399</c:v>
                </c:pt>
                <c:pt idx="26">
                  <c:v>-16.126080038786771</c:v>
                </c:pt>
                <c:pt idx="27">
                  <c:v>15.467960465244985</c:v>
                </c:pt>
                <c:pt idx="28">
                  <c:v>2.4988540699800836</c:v>
                </c:pt>
                <c:pt idx="29">
                  <c:v>-3.3226798449283876</c:v>
                </c:pt>
                <c:pt idx="30">
                  <c:v>-34.748612984403358</c:v>
                </c:pt>
                <c:pt idx="31">
                  <c:v>-16.292746705453425</c:v>
                </c:pt>
                <c:pt idx="32">
                  <c:v>35.420373837350006</c:v>
                </c:pt>
                <c:pt idx="33">
                  <c:v>-7.1476666666817543</c:v>
                </c:pt>
                <c:pt idx="34">
                  <c:v>-14.296679844928384</c:v>
                </c:pt>
                <c:pt idx="35">
                  <c:v>23.945893604719963</c:v>
                </c:pt>
                <c:pt idx="36">
                  <c:v>0.83467984489825398</c:v>
                </c:pt>
                <c:pt idx="37">
                  <c:v>-32.419693023175014</c:v>
                </c:pt>
                <c:pt idx="38">
                  <c:v>-23.274612984403358</c:v>
                </c:pt>
                <c:pt idx="39">
                  <c:v>-4.318746705453421</c:v>
                </c:pt>
                <c:pt idx="40">
                  <c:v>18.129253294546608</c:v>
                </c:pt>
                <c:pt idx="41">
                  <c:v>26.774333333318253</c:v>
                </c:pt>
                <c:pt idx="42">
                  <c:v>8.4836930231449017</c:v>
                </c:pt>
                <c:pt idx="43">
                  <c:v>16.133186434021574</c:v>
                </c:pt>
                <c:pt idx="44">
                  <c:v>2.1684934108616645</c:v>
                </c:pt>
                <c:pt idx="45">
                  <c:v>-4.1427730619466168</c:v>
                </c:pt>
                <c:pt idx="46">
                  <c:v>0.68566666665163467</c:v>
                </c:pt>
                <c:pt idx="47">
                  <c:v>45.081666666651607</c:v>
                </c:pt>
                <c:pt idx="48">
                  <c:v>7.3523333333183345</c:v>
                </c:pt>
                <c:pt idx="49">
                  <c:v>30.989066860510007</c:v>
                </c:pt>
                <c:pt idx="50">
                  <c:v>55.028787209454912</c:v>
                </c:pt>
                <c:pt idx="51">
                  <c:v>60.629334302609799</c:v>
                </c:pt>
                <c:pt idx="52">
                  <c:v>84.386588566463161</c:v>
                </c:pt>
                <c:pt idx="53">
                  <c:v>131.23565445769628</c:v>
                </c:pt>
                <c:pt idx="54">
                  <c:v>247.04001511681443</c:v>
                </c:pt>
                <c:pt idx="55">
                  <c:v>335.39790775225725</c:v>
                </c:pt>
                <c:pt idx="56">
                  <c:v>372.79093507804225</c:v>
                </c:pt>
                <c:pt idx="57">
                  <c:v>283.35914786857256</c:v>
                </c:pt>
                <c:pt idx="58">
                  <c:v>178.92784089173298</c:v>
                </c:pt>
                <c:pt idx="59">
                  <c:v>183.66552073664624</c:v>
                </c:pt>
                <c:pt idx="60">
                  <c:v>168.15132015507129</c:v>
                </c:pt>
                <c:pt idx="61">
                  <c:v>77.068027325769634</c:v>
                </c:pt>
                <c:pt idx="62">
                  <c:v>75.356746705423035</c:v>
                </c:pt>
                <c:pt idx="63">
                  <c:v>70.169453876121537</c:v>
                </c:pt>
                <c:pt idx="64">
                  <c:v>34.211666666651432</c:v>
                </c:pt>
                <c:pt idx="65">
                  <c:v>40.483693023144831</c:v>
                </c:pt>
                <c:pt idx="66">
                  <c:v>-24.538773061946696</c:v>
                </c:pt>
                <c:pt idx="67">
                  <c:v>25.704280620331652</c:v>
                </c:pt>
                <c:pt idx="68">
                  <c:v>5.3955065891082512</c:v>
                </c:pt>
                <c:pt idx="69">
                  <c:v>9.6905602713866728</c:v>
                </c:pt>
                <c:pt idx="70">
                  <c:v>52.240467054368331</c:v>
                </c:pt>
                <c:pt idx="71">
                  <c:v>38.103733527176608</c:v>
                </c:pt>
                <c:pt idx="72">
                  <c:v>22.967000000000006</c:v>
                </c:pt>
                <c:pt idx="73">
                  <c:v>-19.775573449663405</c:v>
                </c:pt>
                <c:pt idx="74">
                  <c:v>9.6503596898115447</c:v>
                </c:pt>
                <c:pt idx="75">
                  <c:v>0.17242655033661691</c:v>
                </c:pt>
                <c:pt idx="76">
                  <c:v>9.9802401162999601</c:v>
                </c:pt>
                <c:pt idx="77">
                  <c:v>16.461626162619844</c:v>
                </c:pt>
                <c:pt idx="78">
                  <c:v>16.795919961213237</c:v>
                </c:pt>
                <c:pt idx="79">
                  <c:v>4.4939604652449816</c:v>
                </c:pt>
                <c:pt idx="80">
                  <c:v>101.26485406998009</c:v>
                </c:pt>
                <c:pt idx="81">
                  <c:v>-14.296679844928391</c:v>
                </c:pt>
                <c:pt idx="82">
                  <c:v>-34.748612984403358</c:v>
                </c:pt>
                <c:pt idx="83">
                  <c:v>-5.3187467054534281</c:v>
                </c:pt>
                <c:pt idx="84">
                  <c:v>-8.4756261626499878</c:v>
                </c:pt>
                <c:pt idx="85">
                  <c:v>-7.1476666666817543</c:v>
                </c:pt>
                <c:pt idx="86">
                  <c:v>-36.244679844928378</c:v>
                </c:pt>
                <c:pt idx="87">
                  <c:v>-41.898106395280038</c:v>
                </c:pt>
                <c:pt idx="88">
                  <c:v>11.808679844898258</c:v>
                </c:pt>
                <c:pt idx="89">
                  <c:v>0.5023069768249897</c:v>
                </c:pt>
                <c:pt idx="90">
                  <c:v>-1.3266129844033507</c:v>
                </c:pt>
                <c:pt idx="91">
                  <c:v>6.6552532945465828</c:v>
                </c:pt>
                <c:pt idx="92">
                  <c:v>-3.8187467054533997</c:v>
                </c:pt>
                <c:pt idx="93">
                  <c:v>-17.12166666668174</c:v>
                </c:pt>
                <c:pt idx="94">
                  <c:v>-13.464306976855092</c:v>
                </c:pt>
                <c:pt idx="95">
                  <c:v>-5.8148135659784259</c:v>
                </c:pt>
                <c:pt idx="96">
                  <c:v>2.1684934108616645</c:v>
                </c:pt>
                <c:pt idx="97">
                  <c:v>-15.116773061946621</c:v>
                </c:pt>
                <c:pt idx="98">
                  <c:v>-21.262333333348359</c:v>
                </c:pt>
                <c:pt idx="99">
                  <c:v>23.133666666651614</c:v>
                </c:pt>
                <c:pt idx="100">
                  <c:v>29.300333333318342</c:v>
                </c:pt>
                <c:pt idx="101">
                  <c:v>30.989066860510007</c:v>
                </c:pt>
                <c:pt idx="102">
                  <c:v>66.002787209454908</c:v>
                </c:pt>
                <c:pt idx="103">
                  <c:v>71.603334302609795</c:v>
                </c:pt>
                <c:pt idx="104">
                  <c:v>95.36058856646315</c:v>
                </c:pt>
                <c:pt idx="105">
                  <c:v>120.2616544576963</c:v>
                </c:pt>
                <c:pt idx="106">
                  <c:v>170.22201511681445</c:v>
                </c:pt>
                <c:pt idx="107">
                  <c:v>335.39790775225725</c:v>
                </c:pt>
                <c:pt idx="108">
                  <c:v>372.79093507804225</c:v>
                </c:pt>
                <c:pt idx="109">
                  <c:v>250.43714786857262</c:v>
                </c:pt>
                <c:pt idx="110">
                  <c:v>255.74584089173297</c:v>
                </c:pt>
                <c:pt idx="111">
                  <c:v>150.74352073664627</c:v>
                </c:pt>
                <c:pt idx="112">
                  <c:v>179.12532015507128</c:v>
                </c:pt>
                <c:pt idx="113">
                  <c:v>88.042027325769652</c:v>
                </c:pt>
                <c:pt idx="114">
                  <c:v>97.304746705423071</c:v>
                </c:pt>
                <c:pt idx="115">
                  <c:v>92.117453876121544</c:v>
                </c:pt>
                <c:pt idx="116">
                  <c:v>45.185666666651436</c:v>
                </c:pt>
                <c:pt idx="117">
                  <c:v>29.509693023144834</c:v>
                </c:pt>
                <c:pt idx="118">
                  <c:v>8.3832269380533049</c:v>
                </c:pt>
                <c:pt idx="119">
                  <c:v>58.626280620331649</c:v>
                </c:pt>
                <c:pt idx="120">
                  <c:v>38.317506589108255</c:v>
                </c:pt>
                <c:pt idx="121">
                  <c:v>20.664560271386677</c:v>
                </c:pt>
                <c:pt idx="122">
                  <c:v>-24.577532945631674</c:v>
                </c:pt>
                <c:pt idx="123">
                  <c:v>-5.7922664728233926</c:v>
                </c:pt>
                <c:pt idx="124">
                  <c:v>11.993000000000002</c:v>
                </c:pt>
                <c:pt idx="125">
                  <c:v>35.094426550336586</c:v>
                </c:pt>
                <c:pt idx="126">
                  <c:v>-12.297640310188456</c:v>
                </c:pt>
                <c:pt idx="127">
                  <c:v>0.17242655033661691</c:v>
                </c:pt>
                <c:pt idx="128">
                  <c:v>-44.889759883700044</c:v>
                </c:pt>
                <c:pt idx="129">
                  <c:v>-16.460373837380157</c:v>
                </c:pt>
                <c:pt idx="130">
                  <c:v>5.8219199612132329</c:v>
                </c:pt>
                <c:pt idx="131">
                  <c:v>-17.454039534755012</c:v>
                </c:pt>
                <c:pt idx="132">
                  <c:v>-41.397145930019917</c:v>
                </c:pt>
                <c:pt idx="133">
                  <c:v>-36.244679844928385</c:v>
                </c:pt>
                <c:pt idx="134">
                  <c:v>-1.8266129844033543</c:v>
                </c:pt>
                <c:pt idx="135">
                  <c:v>-5.3187467054534281</c:v>
                </c:pt>
                <c:pt idx="136">
                  <c:v>-30.423626162649995</c:v>
                </c:pt>
                <c:pt idx="137">
                  <c:v>-18.121666666681751</c:v>
                </c:pt>
                <c:pt idx="138">
                  <c:v>-36.244679844928378</c:v>
                </c:pt>
                <c:pt idx="139">
                  <c:v>-8.9761063952800377</c:v>
                </c:pt>
                <c:pt idx="140">
                  <c:v>0.83467984489825398</c:v>
                </c:pt>
                <c:pt idx="141">
                  <c:v>-21.445693023175018</c:v>
                </c:pt>
                <c:pt idx="142">
                  <c:v>-12.300612984403354</c:v>
                </c:pt>
                <c:pt idx="143">
                  <c:v>-26.266746705453414</c:v>
                </c:pt>
                <c:pt idx="144">
                  <c:v>-3.8187467054533997</c:v>
                </c:pt>
                <c:pt idx="145">
                  <c:v>-6.1476666666817437</c:v>
                </c:pt>
                <c:pt idx="146">
                  <c:v>-2.4903069768550949</c:v>
                </c:pt>
                <c:pt idx="147">
                  <c:v>-5.8148135659784259</c:v>
                </c:pt>
                <c:pt idx="148">
                  <c:v>-30.753506589138336</c:v>
                </c:pt>
                <c:pt idx="149">
                  <c:v>-26.090773061946617</c:v>
                </c:pt>
                <c:pt idx="150">
                  <c:v>33.607666666651632</c:v>
                </c:pt>
                <c:pt idx="151">
                  <c:v>-9.7883333333483868</c:v>
                </c:pt>
                <c:pt idx="152">
                  <c:v>-3.6216666666816657</c:v>
                </c:pt>
                <c:pt idx="153">
                  <c:v>-12.90693313949</c:v>
                </c:pt>
                <c:pt idx="154">
                  <c:v>87.950787209454916</c:v>
                </c:pt>
                <c:pt idx="155">
                  <c:v>170.36933430260981</c:v>
                </c:pt>
                <c:pt idx="156">
                  <c:v>314.84058856646311</c:v>
                </c:pt>
                <c:pt idx="157">
                  <c:v>251.94965445769631</c:v>
                </c:pt>
                <c:pt idx="158">
                  <c:v>236.06601511681444</c:v>
                </c:pt>
                <c:pt idx="159">
                  <c:v>335.39790775225725</c:v>
                </c:pt>
                <c:pt idx="160">
                  <c:v>306.9469350780422</c:v>
                </c:pt>
                <c:pt idx="161">
                  <c:v>239.46314786857263</c:v>
                </c:pt>
                <c:pt idx="162">
                  <c:v>167.95384089173297</c:v>
                </c:pt>
                <c:pt idx="163">
                  <c:v>128.79552073664627</c:v>
                </c:pt>
                <c:pt idx="164">
                  <c:v>146.20332015507128</c:v>
                </c:pt>
                <c:pt idx="165">
                  <c:v>99.016027325769642</c:v>
                </c:pt>
                <c:pt idx="166">
                  <c:v>53.408746705423049</c:v>
                </c:pt>
                <c:pt idx="167">
                  <c:v>48.221453876121551</c:v>
                </c:pt>
                <c:pt idx="168">
                  <c:v>67.133666666651436</c:v>
                </c:pt>
                <c:pt idx="169">
                  <c:v>7.5616930231448336</c:v>
                </c:pt>
                <c:pt idx="170">
                  <c:v>41.305226938053302</c:v>
                </c:pt>
                <c:pt idx="171">
                  <c:v>47.652280620331645</c:v>
                </c:pt>
                <c:pt idx="172">
                  <c:v>49.291506589108259</c:v>
                </c:pt>
                <c:pt idx="173">
                  <c:v>20.664560271386677</c:v>
                </c:pt>
                <c:pt idx="174">
                  <c:v>107.11046705436834</c:v>
                </c:pt>
                <c:pt idx="175">
                  <c:v>27.129733527176604</c:v>
                </c:pt>
                <c:pt idx="176">
                  <c:v>1.0189999999999984</c:v>
                </c:pt>
                <c:pt idx="177">
                  <c:v>24.120426550336596</c:v>
                </c:pt>
                <c:pt idx="178">
                  <c:v>9.6503596898115447</c:v>
                </c:pt>
                <c:pt idx="179">
                  <c:v>11.146426550336621</c:v>
                </c:pt>
                <c:pt idx="180">
                  <c:v>-11.967759883700047</c:v>
                </c:pt>
                <c:pt idx="181">
                  <c:v>-16.460373837380157</c:v>
                </c:pt>
                <c:pt idx="182">
                  <c:v>-27.100080038786771</c:v>
                </c:pt>
                <c:pt idx="183">
                  <c:v>15.467960465244985</c:v>
                </c:pt>
                <c:pt idx="184">
                  <c:v>-41.397145930019917</c:v>
                </c:pt>
                <c:pt idx="185">
                  <c:v>51.54732015507161</c:v>
                </c:pt>
                <c:pt idx="186">
                  <c:v>20.121387015596639</c:v>
                </c:pt>
                <c:pt idx="187">
                  <c:v>27.603253294546569</c:v>
                </c:pt>
                <c:pt idx="188">
                  <c:v>2.4983738373500017</c:v>
                </c:pt>
                <c:pt idx="189">
                  <c:v>3.826333333318253</c:v>
                </c:pt>
                <c:pt idx="190">
                  <c:v>-14.296679844928384</c:v>
                </c:pt>
                <c:pt idx="191">
                  <c:v>12.971893604719959</c:v>
                </c:pt>
                <c:pt idx="192">
                  <c:v>22.782679844898261</c:v>
                </c:pt>
                <c:pt idx="193">
                  <c:v>-21.445693023175018</c:v>
                </c:pt>
                <c:pt idx="194">
                  <c:v>64.517387015596654</c:v>
                </c:pt>
                <c:pt idx="195">
                  <c:v>17.629253294546587</c:v>
                </c:pt>
                <c:pt idx="196">
                  <c:v>18.129253294546608</c:v>
                </c:pt>
                <c:pt idx="197">
                  <c:v>-6.1476666666817437</c:v>
                </c:pt>
                <c:pt idx="198">
                  <c:v>19.457693023144905</c:v>
                </c:pt>
                <c:pt idx="199">
                  <c:v>-5.8148135659784259</c:v>
                </c:pt>
                <c:pt idx="200">
                  <c:v>24.116493410861658</c:v>
                </c:pt>
                <c:pt idx="201">
                  <c:v>-4.1427730619466168</c:v>
                </c:pt>
                <c:pt idx="202">
                  <c:v>0.68566666665163467</c:v>
                </c:pt>
                <c:pt idx="203">
                  <c:v>12.15966666665161</c:v>
                </c:pt>
                <c:pt idx="204">
                  <c:v>7.3523333333183345</c:v>
                </c:pt>
                <c:pt idx="205">
                  <c:v>41.96306686050999</c:v>
                </c:pt>
                <c:pt idx="206">
                  <c:v>11.132787209454911</c:v>
                </c:pt>
                <c:pt idx="207">
                  <c:v>49.655334302609795</c:v>
                </c:pt>
                <c:pt idx="208">
                  <c:v>21.005188372605168</c:v>
                </c:pt>
                <c:pt idx="209">
                  <c:v>7.5685885664631343</c:v>
                </c:pt>
                <c:pt idx="210">
                  <c:v>120.2616544576963</c:v>
                </c:pt>
                <c:pt idx="211">
                  <c:v>236.06601511681444</c:v>
                </c:pt>
                <c:pt idx="212">
                  <c:v>401.24190775225725</c:v>
                </c:pt>
                <c:pt idx="213">
                  <c:v>383.76493507804219</c:v>
                </c:pt>
                <c:pt idx="214">
                  <c:v>338.22914786857257</c:v>
                </c:pt>
                <c:pt idx="215">
                  <c:v>255.74584089173297</c:v>
                </c:pt>
                <c:pt idx="216">
                  <c:v>271.45752073664625</c:v>
                </c:pt>
                <c:pt idx="217">
                  <c:v>179.12532015507128</c:v>
                </c:pt>
                <c:pt idx="218">
                  <c:v>186.80802732576964</c:v>
                </c:pt>
                <c:pt idx="219">
                  <c:v>75.356746705423035</c:v>
                </c:pt>
                <c:pt idx="220">
                  <c:v>114.06545387612155</c:v>
                </c:pt>
                <c:pt idx="221">
                  <c:v>45.185666666651436</c:v>
                </c:pt>
                <c:pt idx="222">
                  <c:v>51.457693023144834</c:v>
                </c:pt>
                <c:pt idx="223">
                  <c:v>19.357226938053309</c:v>
                </c:pt>
                <c:pt idx="224">
                  <c:v>69.60028062033166</c:v>
                </c:pt>
                <c:pt idx="225">
                  <c:v>16.369506589108248</c:v>
                </c:pt>
                <c:pt idx="226">
                  <c:v>42.612560271386663</c:v>
                </c:pt>
                <c:pt idx="227">
                  <c:v>-24.577532945631674</c:v>
                </c:pt>
                <c:pt idx="228">
                  <c:v>-5.7922664728233926</c:v>
                </c:pt>
                <c:pt idx="229">
                  <c:v>11.993000000000002</c:v>
                </c:pt>
                <c:pt idx="230">
                  <c:v>-8.8015734496634046</c:v>
                </c:pt>
                <c:pt idx="231">
                  <c:v>9.6503596898115447</c:v>
                </c:pt>
                <c:pt idx="232">
                  <c:v>11.146426550336621</c:v>
                </c:pt>
                <c:pt idx="233">
                  <c:v>53.876240116299961</c:v>
                </c:pt>
                <c:pt idx="234">
                  <c:v>5.4876261626198399</c:v>
                </c:pt>
                <c:pt idx="235">
                  <c:v>16.795919961213237</c:v>
                </c:pt>
                <c:pt idx="236">
                  <c:v>15.467960465244985</c:v>
                </c:pt>
                <c:pt idx="237">
                  <c:v>-30.423145930019913</c:v>
                </c:pt>
                <c:pt idx="238">
                  <c:v>-14.296679844928391</c:v>
                </c:pt>
                <c:pt idx="239">
                  <c:v>-1.8266129844033543</c:v>
                </c:pt>
                <c:pt idx="240">
                  <c:v>16.629253294546579</c:v>
                </c:pt>
                <c:pt idx="241">
                  <c:v>-8.4756261626499878</c:v>
                </c:pt>
                <c:pt idx="242">
                  <c:v>14.800333333318257</c:v>
                </c:pt>
                <c:pt idx="243">
                  <c:v>29.599320155071617</c:v>
                </c:pt>
                <c:pt idx="244">
                  <c:v>34.919893604719967</c:v>
                </c:pt>
                <c:pt idx="245">
                  <c:v>-10.139320155101739</c:v>
                </c:pt>
                <c:pt idx="246">
                  <c:v>77.32030697682498</c:v>
                </c:pt>
                <c:pt idx="247">
                  <c:v>-23.274612984403358</c:v>
                </c:pt>
                <c:pt idx="248">
                  <c:v>28.603253294546576</c:v>
                </c:pt>
                <c:pt idx="249">
                  <c:v>-3.8187467054533997</c:v>
                </c:pt>
                <c:pt idx="250">
                  <c:v>-6.1476666666817437</c:v>
                </c:pt>
                <c:pt idx="251">
                  <c:v>-2.4903069768550949</c:v>
                </c:pt>
                <c:pt idx="252">
                  <c:v>16.133186434021574</c:v>
                </c:pt>
                <c:pt idx="253">
                  <c:v>2.1684934108616645</c:v>
                </c:pt>
                <c:pt idx="254">
                  <c:v>39.75322693805338</c:v>
                </c:pt>
                <c:pt idx="255">
                  <c:v>55.555666666651639</c:v>
                </c:pt>
                <c:pt idx="256">
                  <c:v>1.1856666666516062</c:v>
                </c:pt>
                <c:pt idx="257">
                  <c:v>29.300333333318342</c:v>
                </c:pt>
                <c:pt idx="258">
                  <c:v>41.96306686050999</c:v>
                </c:pt>
                <c:pt idx="259">
                  <c:v>66.002787209454908</c:v>
                </c:pt>
                <c:pt idx="260">
                  <c:v>192.31733430260982</c:v>
                </c:pt>
                <c:pt idx="261">
                  <c:v>95.36058856646315</c:v>
                </c:pt>
                <c:pt idx="262">
                  <c:v>208.0536544576963</c:v>
                </c:pt>
                <c:pt idx="263">
                  <c:v>411.65001511681442</c:v>
                </c:pt>
                <c:pt idx="264">
                  <c:v>423.18990775225723</c:v>
                </c:pt>
                <c:pt idx="265">
                  <c:v>394.73893507804223</c:v>
                </c:pt>
                <c:pt idx="266">
                  <c:v>327.25514786857258</c:v>
                </c:pt>
                <c:pt idx="267">
                  <c:v>200.87584089173296</c:v>
                </c:pt>
                <c:pt idx="268">
                  <c:v>172.69152073664625</c:v>
                </c:pt>
                <c:pt idx="269">
                  <c:v>146.20332015507128</c:v>
                </c:pt>
                <c:pt idx="270">
                  <c:v>88.042027325769652</c:v>
                </c:pt>
                <c:pt idx="271">
                  <c:v>97.304746705423071</c:v>
                </c:pt>
                <c:pt idx="272">
                  <c:v>26.27345387612155</c:v>
                </c:pt>
                <c:pt idx="273">
                  <c:v>45.185666666651436</c:v>
                </c:pt>
                <c:pt idx="274">
                  <c:v>29.509693023144834</c:v>
                </c:pt>
                <c:pt idx="275">
                  <c:v>41.305226938053302</c:v>
                </c:pt>
                <c:pt idx="276">
                  <c:v>14.730280620331648</c:v>
                </c:pt>
                <c:pt idx="277">
                  <c:v>16.369506589108248</c:v>
                </c:pt>
                <c:pt idx="278">
                  <c:v>9.6905602713866728</c:v>
                </c:pt>
                <c:pt idx="279">
                  <c:v>-24.577532945631674</c:v>
                </c:pt>
                <c:pt idx="280">
                  <c:v>27.129733527176604</c:v>
                </c:pt>
                <c:pt idx="281">
                  <c:v>-9.9549999999999983</c:v>
                </c:pt>
                <c:pt idx="282">
                  <c:v>2.1724265503365885</c:v>
                </c:pt>
                <c:pt idx="283">
                  <c:v>-12.297640310188456</c:v>
                </c:pt>
                <c:pt idx="284">
                  <c:v>0.17242655033661691</c:v>
                </c:pt>
                <c:pt idx="285">
                  <c:v>31.928240116299953</c:v>
                </c:pt>
                <c:pt idx="286">
                  <c:v>5.4876261626198399</c:v>
                </c:pt>
                <c:pt idx="287">
                  <c:v>5.8219199612132329</c:v>
                </c:pt>
                <c:pt idx="288">
                  <c:v>-28.428039534755015</c:v>
                </c:pt>
                <c:pt idx="289">
                  <c:v>13.472854069980087</c:v>
                </c:pt>
                <c:pt idx="290">
                  <c:v>18.625320155071606</c:v>
                </c:pt>
                <c:pt idx="291">
                  <c:v>53.043387015596657</c:v>
                </c:pt>
                <c:pt idx="292">
                  <c:v>-16.292746705453425</c:v>
                </c:pt>
                <c:pt idx="293">
                  <c:v>13.472373837350005</c:v>
                </c:pt>
                <c:pt idx="294">
                  <c:v>14.800333333318257</c:v>
                </c:pt>
                <c:pt idx="295">
                  <c:v>73.495320155071624</c:v>
                </c:pt>
                <c:pt idx="296">
                  <c:v>-19.950106395280041</c:v>
                </c:pt>
                <c:pt idx="297">
                  <c:v>-21.113320155101739</c:v>
                </c:pt>
                <c:pt idx="298">
                  <c:v>0.5023069768249897</c:v>
                </c:pt>
                <c:pt idx="299">
                  <c:v>-1.3266129844033507</c:v>
                </c:pt>
                <c:pt idx="300">
                  <c:v>-15.292746705453418</c:v>
                </c:pt>
                <c:pt idx="301">
                  <c:v>-14.792746705453396</c:v>
                </c:pt>
                <c:pt idx="302">
                  <c:v>15.800333333318264</c:v>
                </c:pt>
                <c:pt idx="303">
                  <c:v>-2.4903069768550949</c:v>
                </c:pt>
                <c:pt idx="304">
                  <c:v>-5.8148135659784259</c:v>
                </c:pt>
                <c:pt idx="305">
                  <c:v>13.142493410861668</c:v>
                </c:pt>
                <c:pt idx="306">
                  <c:v>39.75322693805338</c:v>
                </c:pt>
                <c:pt idx="307">
                  <c:v>-21.262333333348359</c:v>
                </c:pt>
                <c:pt idx="308">
                  <c:v>-20.762333333348387</c:v>
                </c:pt>
                <c:pt idx="309">
                  <c:v>18.326333333318338</c:v>
                </c:pt>
                <c:pt idx="310">
                  <c:v>20.015066860510004</c:v>
                </c:pt>
                <c:pt idx="311">
                  <c:v>109.89878720945492</c:v>
                </c:pt>
                <c:pt idx="312">
                  <c:v>137.4473343026098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B3D-4EC0-A8D6-5E64F831BF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27113808"/>
        <c:axId val="1626116352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1!$B$1</c15:sqref>
                        </c15:formulaRef>
                      </c:ext>
                    </c:extLst>
                    <c:strCache>
                      <c:ptCount val="1"/>
                      <c:pt idx="0">
                        <c:v>発熱トリアージ件数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>
                      <c:ext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1!$B$2:$B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5</c:v>
                      </c:pt>
                      <c:pt idx="1">
                        <c:v>5</c:v>
                      </c:pt>
                      <c:pt idx="2">
                        <c:v>12</c:v>
                      </c:pt>
                      <c:pt idx="3">
                        <c:v>6</c:v>
                      </c:pt>
                      <c:pt idx="4">
                        <c:v>5</c:v>
                      </c:pt>
                      <c:pt idx="5">
                        <c:v>11</c:v>
                      </c:pt>
                      <c:pt idx="6">
                        <c:v>10</c:v>
                      </c:pt>
                      <c:pt idx="7">
                        <c:v>7</c:v>
                      </c:pt>
                      <c:pt idx="8">
                        <c:v>3</c:v>
                      </c:pt>
                      <c:pt idx="9">
                        <c:v>5</c:v>
                      </c:pt>
                      <c:pt idx="10">
                        <c:v>6</c:v>
                      </c:pt>
                      <c:pt idx="11">
                        <c:v>6</c:v>
                      </c:pt>
                      <c:pt idx="12">
                        <c:v>6</c:v>
                      </c:pt>
                      <c:pt idx="13">
                        <c:v>3</c:v>
                      </c:pt>
                      <c:pt idx="14">
                        <c:v>10</c:v>
                      </c:pt>
                      <c:pt idx="15">
                        <c:v>5</c:v>
                      </c:pt>
                      <c:pt idx="16">
                        <c:v>6</c:v>
                      </c:pt>
                      <c:pt idx="17">
                        <c:v>4</c:v>
                      </c:pt>
                      <c:pt idx="18">
                        <c:v>3</c:v>
                      </c:pt>
                      <c:pt idx="19">
                        <c:v>2</c:v>
                      </c:pt>
                      <c:pt idx="20">
                        <c:v>4</c:v>
                      </c:pt>
                      <c:pt idx="21">
                        <c:v>2</c:v>
                      </c:pt>
                      <c:pt idx="22">
                        <c:v>3</c:v>
                      </c:pt>
                      <c:pt idx="23">
                        <c:v>2</c:v>
                      </c:pt>
                      <c:pt idx="24">
                        <c:v>1</c:v>
                      </c:pt>
                      <c:pt idx="25">
                        <c:v>2</c:v>
                      </c:pt>
                      <c:pt idx="26">
                        <c:v>2</c:v>
                      </c:pt>
                      <c:pt idx="27">
                        <c:v>7</c:v>
                      </c:pt>
                      <c:pt idx="28">
                        <c:v>7</c:v>
                      </c:pt>
                      <c:pt idx="29">
                        <c:v>4</c:v>
                      </c:pt>
                      <c:pt idx="30">
                        <c:v>2</c:v>
                      </c:pt>
                      <c:pt idx="31">
                        <c:v>2</c:v>
                      </c:pt>
                      <c:pt idx="32">
                        <c:v>9</c:v>
                      </c:pt>
                      <c:pt idx="33">
                        <c:v>3</c:v>
                      </c:pt>
                      <c:pt idx="34">
                        <c:v>3</c:v>
                      </c:pt>
                      <c:pt idx="35">
                        <c:v>7</c:v>
                      </c:pt>
                      <c:pt idx="36">
                        <c:v>3</c:v>
                      </c:pt>
                      <c:pt idx="37">
                        <c:v>2</c:v>
                      </c:pt>
                      <c:pt idx="38">
                        <c:v>3</c:v>
                      </c:pt>
                      <c:pt idx="39">
                        <c:v>3</c:v>
                      </c:pt>
                      <c:pt idx="40">
                        <c:v>5</c:v>
                      </c:pt>
                      <c:pt idx="41">
                        <c:v>6</c:v>
                      </c:pt>
                      <c:pt idx="42">
                        <c:v>3</c:v>
                      </c:pt>
                      <c:pt idx="43">
                        <c:v>4</c:v>
                      </c:pt>
                      <c:pt idx="44">
                        <c:v>4</c:v>
                      </c:pt>
                      <c:pt idx="45">
                        <c:v>4</c:v>
                      </c:pt>
                      <c:pt idx="46">
                        <c:v>3</c:v>
                      </c:pt>
                      <c:pt idx="47">
                        <c:v>7</c:v>
                      </c:pt>
                      <c:pt idx="48">
                        <c:v>3</c:v>
                      </c:pt>
                      <c:pt idx="49">
                        <c:v>5</c:v>
                      </c:pt>
                      <c:pt idx="50">
                        <c:v>5</c:v>
                      </c:pt>
                      <c:pt idx="51">
                        <c:v>3</c:v>
                      </c:pt>
                      <c:pt idx="52">
                        <c:v>10</c:v>
                      </c:pt>
                      <c:pt idx="53">
                        <c:v>6</c:v>
                      </c:pt>
                      <c:pt idx="54">
                        <c:v>10</c:v>
                      </c:pt>
                      <c:pt idx="55">
                        <c:v>6</c:v>
                      </c:pt>
                      <c:pt idx="56">
                        <c:v>13</c:v>
                      </c:pt>
                      <c:pt idx="57">
                        <c:v>8</c:v>
                      </c:pt>
                      <c:pt idx="58">
                        <c:v>4</c:v>
                      </c:pt>
                      <c:pt idx="59">
                        <c:v>7</c:v>
                      </c:pt>
                      <c:pt idx="60">
                        <c:v>5</c:v>
                      </c:pt>
                      <c:pt idx="61">
                        <c:v>4</c:v>
                      </c:pt>
                      <c:pt idx="62">
                        <c:v>3</c:v>
                      </c:pt>
                      <c:pt idx="63">
                        <c:v>6</c:v>
                      </c:pt>
                      <c:pt idx="64">
                        <c:v>2</c:v>
                      </c:pt>
                      <c:pt idx="65">
                        <c:v>3</c:v>
                      </c:pt>
                      <c:pt idx="66">
                        <c:v>0</c:v>
                      </c:pt>
                      <c:pt idx="67">
                        <c:v>5</c:v>
                      </c:pt>
                      <c:pt idx="68">
                        <c:v>1</c:v>
                      </c:pt>
                      <c:pt idx="69">
                        <c:v>4</c:v>
                      </c:pt>
                      <c:pt idx="70">
                        <c:v>9</c:v>
                      </c:pt>
                      <c:pt idx="71">
                        <c:v>7</c:v>
                      </c:pt>
                      <c:pt idx="72">
                        <c:v>5</c:v>
                      </c:pt>
                      <c:pt idx="73">
                        <c:v>1</c:v>
                      </c:pt>
                      <c:pt idx="74">
                        <c:v>3</c:v>
                      </c:pt>
                      <c:pt idx="75">
                        <c:v>3</c:v>
                      </c:pt>
                      <c:pt idx="76">
                        <c:v>5</c:v>
                      </c:pt>
                      <c:pt idx="77">
                        <c:v>3</c:v>
                      </c:pt>
                      <c:pt idx="78">
                        <c:v>5</c:v>
                      </c:pt>
                      <c:pt idx="79">
                        <c:v>6</c:v>
                      </c:pt>
                      <c:pt idx="80">
                        <c:v>16</c:v>
                      </c:pt>
                      <c:pt idx="81">
                        <c:v>3</c:v>
                      </c:pt>
                      <c:pt idx="82">
                        <c:v>2</c:v>
                      </c:pt>
                      <c:pt idx="83">
                        <c:v>3</c:v>
                      </c:pt>
                      <c:pt idx="84">
                        <c:v>5</c:v>
                      </c:pt>
                      <c:pt idx="85">
                        <c:v>3</c:v>
                      </c:pt>
                      <c:pt idx="86">
                        <c:v>1</c:v>
                      </c:pt>
                      <c:pt idx="87">
                        <c:v>1</c:v>
                      </c:pt>
                      <c:pt idx="88">
                        <c:v>4</c:v>
                      </c:pt>
                      <c:pt idx="89">
                        <c:v>5</c:v>
                      </c:pt>
                      <c:pt idx="90">
                        <c:v>5</c:v>
                      </c:pt>
                      <c:pt idx="91">
                        <c:v>4</c:v>
                      </c:pt>
                      <c:pt idx="92">
                        <c:v>3</c:v>
                      </c:pt>
                      <c:pt idx="93">
                        <c:v>2</c:v>
                      </c:pt>
                      <c:pt idx="94">
                        <c:v>1</c:v>
                      </c:pt>
                      <c:pt idx="95">
                        <c:v>2</c:v>
                      </c:pt>
                      <c:pt idx="96">
                        <c:v>4</c:v>
                      </c:pt>
                      <c:pt idx="97">
                        <c:v>3</c:v>
                      </c:pt>
                      <c:pt idx="98">
                        <c:v>1</c:v>
                      </c:pt>
                      <c:pt idx="99">
                        <c:v>5</c:v>
                      </c:pt>
                      <c:pt idx="100">
                        <c:v>5</c:v>
                      </c:pt>
                      <c:pt idx="101">
                        <c:v>5</c:v>
                      </c:pt>
                      <c:pt idx="102">
                        <c:v>6</c:v>
                      </c:pt>
                      <c:pt idx="103">
                        <c:v>4</c:v>
                      </c:pt>
                      <c:pt idx="104">
                        <c:v>11</c:v>
                      </c:pt>
                      <c:pt idx="105">
                        <c:v>5</c:v>
                      </c:pt>
                      <c:pt idx="106">
                        <c:v>3</c:v>
                      </c:pt>
                      <c:pt idx="107">
                        <c:v>6</c:v>
                      </c:pt>
                      <c:pt idx="108">
                        <c:v>13</c:v>
                      </c:pt>
                      <c:pt idx="109">
                        <c:v>5</c:v>
                      </c:pt>
                      <c:pt idx="110">
                        <c:v>11</c:v>
                      </c:pt>
                      <c:pt idx="111">
                        <c:v>4</c:v>
                      </c:pt>
                      <c:pt idx="112">
                        <c:v>6</c:v>
                      </c:pt>
                      <c:pt idx="113">
                        <c:v>5</c:v>
                      </c:pt>
                      <c:pt idx="114">
                        <c:v>5</c:v>
                      </c:pt>
                      <c:pt idx="115">
                        <c:v>8</c:v>
                      </c:pt>
                      <c:pt idx="116">
                        <c:v>3</c:v>
                      </c:pt>
                      <c:pt idx="117">
                        <c:v>2</c:v>
                      </c:pt>
                      <c:pt idx="118">
                        <c:v>3</c:v>
                      </c:pt>
                      <c:pt idx="119">
                        <c:v>8</c:v>
                      </c:pt>
                      <c:pt idx="120">
                        <c:v>4</c:v>
                      </c:pt>
                      <c:pt idx="121">
                        <c:v>5</c:v>
                      </c:pt>
                      <c:pt idx="122">
                        <c:v>2</c:v>
                      </c:pt>
                      <c:pt idx="123">
                        <c:v>3</c:v>
                      </c:pt>
                      <c:pt idx="124">
                        <c:v>4</c:v>
                      </c:pt>
                      <c:pt idx="125">
                        <c:v>6</c:v>
                      </c:pt>
                      <c:pt idx="126">
                        <c:v>1</c:v>
                      </c:pt>
                      <c:pt idx="127">
                        <c:v>3</c:v>
                      </c:pt>
                      <c:pt idx="128">
                        <c:v>0</c:v>
                      </c:pt>
                      <c:pt idx="129">
                        <c:v>0</c:v>
                      </c:pt>
                      <c:pt idx="130">
                        <c:v>4</c:v>
                      </c:pt>
                      <c:pt idx="131">
                        <c:v>4</c:v>
                      </c:pt>
                      <c:pt idx="132">
                        <c:v>3</c:v>
                      </c:pt>
                      <c:pt idx="133">
                        <c:v>1</c:v>
                      </c:pt>
                      <c:pt idx="134">
                        <c:v>5</c:v>
                      </c:pt>
                      <c:pt idx="135">
                        <c:v>3</c:v>
                      </c:pt>
                      <c:pt idx="136">
                        <c:v>3</c:v>
                      </c:pt>
                      <c:pt idx="137">
                        <c:v>2</c:v>
                      </c:pt>
                      <c:pt idx="138">
                        <c:v>1</c:v>
                      </c:pt>
                      <c:pt idx="139">
                        <c:v>4</c:v>
                      </c:pt>
                      <c:pt idx="140">
                        <c:v>3</c:v>
                      </c:pt>
                      <c:pt idx="141">
                        <c:v>3</c:v>
                      </c:pt>
                      <c:pt idx="142">
                        <c:v>4</c:v>
                      </c:pt>
                      <c:pt idx="143">
                        <c:v>1</c:v>
                      </c:pt>
                      <c:pt idx="144">
                        <c:v>3</c:v>
                      </c:pt>
                      <c:pt idx="145">
                        <c:v>3</c:v>
                      </c:pt>
                      <c:pt idx="146">
                        <c:v>2</c:v>
                      </c:pt>
                      <c:pt idx="147">
                        <c:v>2</c:v>
                      </c:pt>
                      <c:pt idx="148">
                        <c:v>1</c:v>
                      </c:pt>
                      <c:pt idx="149">
                        <c:v>2</c:v>
                      </c:pt>
                      <c:pt idx="150">
                        <c:v>6</c:v>
                      </c:pt>
                      <c:pt idx="151">
                        <c:v>2</c:v>
                      </c:pt>
                      <c:pt idx="152">
                        <c:v>2</c:v>
                      </c:pt>
                      <c:pt idx="153">
                        <c:v>1</c:v>
                      </c:pt>
                      <c:pt idx="154">
                        <c:v>8</c:v>
                      </c:pt>
                      <c:pt idx="155">
                        <c:v>13</c:v>
                      </c:pt>
                      <c:pt idx="156">
                        <c:v>31</c:v>
                      </c:pt>
                      <c:pt idx="157">
                        <c:v>17</c:v>
                      </c:pt>
                      <c:pt idx="158">
                        <c:v>9</c:v>
                      </c:pt>
                      <c:pt idx="159">
                        <c:v>6</c:v>
                      </c:pt>
                      <c:pt idx="160">
                        <c:v>7</c:v>
                      </c:pt>
                      <c:pt idx="161">
                        <c:v>4</c:v>
                      </c:pt>
                      <c:pt idx="162">
                        <c:v>3</c:v>
                      </c:pt>
                      <c:pt idx="163">
                        <c:v>2</c:v>
                      </c:pt>
                      <c:pt idx="164">
                        <c:v>3</c:v>
                      </c:pt>
                      <c:pt idx="165">
                        <c:v>6</c:v>
                      </c:pt>
                      <c:pt idx="166">
                        <c:v>1</c:v>
                      </c:pt>
                      <c:pt idx="167">
                        <c:v>4</c:v>
                      </c:pt>
                      <c:pt idx="168">
                        <c:v>5</c:v>
                      </c:pt>
                      <c:pt idx="169">
                        <c:v>0</c:v>
                      </c:pt>
                      <c:pt idx="170">
                        <c:v>6</c:v>
                      </c:pt>
                      <c:pt idx="171">
                        <c:v>7</c:v>
                      </c:pt>
                      <c:pt idx="172">
                        <c:v>5</c:v>
                      </c:pt>
                      <c:pt idx="173">
                        <c:v>5</c:v>
                      </c:pt>
                      <c:pt idx="174">
                        <c:v>14</c:v>
                      </c:pt>
                      <c:pt idx="175">
                        <c:v>6</c:v>
                      </c:pt>
                      <c:pt idx="176">
                        <c:v>3</c:v>
                      </c:pt>
                      <c:pt idx="177">
                        <c:v>5</c:v>
                      </c:pt>
                      <c:pt idx="178">
                        <c:v>3</c:v>
                      </c:pt>
                      <c:pt idx="179">
                        <c:v>4</c:v>
                      </c:pt>
                      <c:pt idx="180">
                        <c:v>3</c:v>
                      </c:pt>
                      <c:pt idx="181">
                        <c:v>0</c:v>
                      </c:pt>
                      <c:pt idx="182">
                        <c:v>1</c:v>
                      </c:pt>
                      <c:pt idx="183">
                        <c:v>7</c:v>
                      </c:pt>
                      <c:pt idx="184">
                        <c:v>3</c:v>
                      </c:pt>
                      <c:pt idx="185">
                        <c:v>9</c:v>
                      </c:pt>
                      <c:pt idx="186">
                        <c:v>7</c:v>
                      </c:pt>
                      <c:pt idx="187">
                        <c:v>6</c:v>
                      </c:pt>
                      <c:pt idx="188">
                        <c:v>6</c:v>
                      </c:pt>
                      <c:pt idx="189">
                        <c:v>4</c:v>
                      </c:pt>
                      <c:pt idx="190">
                        <c:v>3</c:v>
                      </c:pt>
                      <c:pt idx="191">
                        <c:v>6</c:v>
                      </c:pt>
                      <c:pt idx="192">
                        <c:v>5</c:v>
                      </c:pt>
                      <c:pt idx="193">
                        <c:v>3</c:v>
                      </c:pt>
                      <c:pt idx="194">
                        <c:v>11</c:v>
                      </c:pt>
                      <c:pt idx="195">
                        <c:v>5</c:v>
                      </c:pt>
                      <c:pt idx="196">
                        <c:v>5</c:v>
                      </c:pt>
                      <c:pt idx="197">
                        <c:v>3</c:v>
                      </c:pt>
                      <c:pt idx="198">
                        <c:v>4</c:v>
                      </c:pt>
                      <c:pt idx="199">
                        <c:v>2</c:v>
                      </c:pt>
                      <c:pt idx="200">
                        <c:v>6</c:v>
                      </c:pt>
                      <c:pt idx="201">
                        <c:v>4</c:v>
                      </c:pt>
                      <c:pt idx="202">
                        <c:v>3</c:v>
                      </c:pt>
                      <c:pt idx="203">
                        <c:v>4</c:v>
                      </c:pt>
                      <c:pt idx="204">
                        <c:v>3</c:v>
                      </c:pt>
                      <c:pt idx="205">
                        <c:v>6</c:v>
                      </c:pt>
                      <c:pt idx="206">
                        <c:v>1</c:v>
                      </c:pt>
                      <c:pt idx="207">
                        <c:v>2</c:v>
                      </c:pt>
                      <c:pt idx="208">
                        <c:v>11</c:v>
                      </c:pt>
                      <c:pt idx="209">
                        <c:v>3</c:v>
                      </c:pt>
                      <c:pt idx="210">
                        <c:v>5</c:v>
                      </c:pt>
                      <c:pt idx="211">
                        <c:v>9</c:v>
                      </c:pt>
                      <c:pt idx="212">
                        <c:v>12</c:v>
                      </c:pt>
                      <c:pt idx="213">
                        <c:v>14</c:v>
                      </c:pt>
                      <c:pt idx="214">
                        <c:v>13</c:v>
                      </c:pt>
                      <c:pt idx="215">
                        <c:v>11</c:v>
                      </c:pt>
                      <c:pt idx="216">
                        <c:v>15</c:v>
                      </c:pt>
                      <c:pt idx="217">
                        <c:v>6</c:v>
                      </c:pt>
                      <c:pt idx="218">
                        <c:v>14</c:v>
                      </c:pt>
                      <c:pt idx="219">
                        <c:v>3</c:v>
                      </c:pt>
                      <c:pt idx="220">
                        <c:v>10</c:v>
                      </c:pt>
                      <c:pt idx="221">
                        <c:v>3</c:v>
                      </c:pt>
                      <c:pt idx="222">
                        <c:v>4</c:v>
                      </c:pt>
                      <c:pt idx="223">
                        <c:v>4</c:v>
                      </c:pt>
                      <c:pt idx="224">
                        <c:v>9</c:v>
                      </c:pt>
                      <c:pt idx="225">
                        <c:v>2</c:v>
                      </c:pt>
                      <c:pt idx="226">
                        <c:v>7</c:v>
                      </c:pt>
                      <c:pt idx="227">
                        <c:v>2</c:v>
                      </c:pt>
                      <c:pt idx="228">
                        <c:v>3</c:v>
                      </c:pt>
                      <c:pt idx="229">
                        <c:v>4</c:v>
                      </c:pt>
                      <c:pt idx="230">
                        <c:v>2</c:v>
                      </c:pt>
                      <c:pt idx="231">
                        <c:v>3</c:v>
                      </c:pt>
                      <c:pt idx="232">
                        <c:v>4</c:v>
                      </c:pt>
                      <c:pt idx="233">
                        <c:v>9</c:v>
                      </c:pt>
                      <c:pt idx="234">
                        <c:v>2</c:v>
                      </c:pt>
                      <c:pt idx="235">
                        <c:v>5</c:v>
                      </c:pt>
                      <c:pt idx="236">
                        <c:v>7</c:v>
                      </c:pt>
                      <c:pt idx="237">
                        <c:v>4</c:v>
                      </c:pt>
                      <c:pt idx="238">
                        <c:v>3</c:v>
                      </c:pt>
                      <c:pt idx="239">
                        <c:v>5</c:v>
                      </c:pt>
                      <c:pt idx="240">
                        <c:v>5</c:v>
                      </c:pt>
                      <c:pt idx="241">
                        <c:v>5</c:v>
                      </c:pt>
                      <c:pt idx="242">
                        <c:v>5</c:v>
                      </c:pt>
                      <c:pt idx="243">
                        <c:v>7</c:v>
                      </c:pt>
                      <c:pt idx="244">
                        <c:v>8</c:v>
                      </c:pt>
                      <c:pt idx="245">
                        <c:v>2</c:v>
                      </c:pt>
                      <c:pt idx="246">
                        <c:v>12</c:v>
                      </c:pt>
                      <c:pt idx="247">
                        <c:v>3</c:v>
                      </c:pt>
                      <c:pt idx="248">
                        <c:v>6</c:v>
                      </c:pt>
                      <c:pt idx="249">
                        <c:v>3</c:v>
                      </c:pt>
                      <c:pt idx="250">
                        <c:v>3</c:v>
                      </c:pt>
                      <c:pt idx="251">
                        <c:v>2</c:v>
                      </c:pt>
                      <c:pt idx="252">
                        <c:v>4</c:v>
                      </c:pt>
                      <c:pt idx="253">
                        <c:v>4</c:v>
                      </c:pt>
                      <c:pt idx="254">
                        <c:v>8</c:v>
                      </c:pt>
                      <c:pt idx="255">
                        <c:v>8</c:v>
                      </c:pt>
                      <c:pt idx="256">
                        <c:v>3</c:v>
                      </c:pt>
                      <c:pt idx="257">
                        <c:v>5</c:v>
                      </c:pt>
                      <c:pt idx="258">
                        <c:v>6</c:v>
                      </c:pt>
                      <c:pt idx="259">
                        <c:v>6</c:v>
                      </c:pt>
                      <c:pt idx="260">
                        <c:v>15</c:v>
                      </c:pt>
                      <c:pt idx="261">
                        <c:v>11</c:v>
                      </c:pt>
                      <c:pt idx="262">
                        <c:v>13</c:v>
                      </c:pt>
                      <c:pt idx="263">
                        <c:v>25</c:v>
                      </c:pt>
                      <c:pt idx="264">
                        <c:v>14</c:v>
                      </c:pt>
                      <c:pt idx="265">
                        <c:v>15</c:v>
                      </c:pt>
                      <c:pt idx="266">
                        <c:v>12</c:v>
                      </c:pt>
                      <c:pt idx="267">
                        <c:v>6</c:v>
                      </c:pt>
                      <c:pt idx="268">
                        <c:v>6</c:v>
                      </c:pt>
                      <c:pt idx="269">
                        <c:v>3</c:v>
                      </c:pt>
                      <c:pt idx="270">
                        <c:v>5</c:v>
                      </c:pt>
                      <c:pt idx="271">
                        <c:v>5</c:v>
                      </c:pt>
                      <c:pt idx="272">
                        <c:v>2</c:v>
                      </c:pt>
                      <c:pt idx="273">
                        <c:v>3</c:v>
                      </c:pt>
                      <c:pt idx="274">
                        <c:v>2</c:v>
                      </c:pt>
                      <c:pt idx="275">
                        <c:v>6</c:v>
                      </c:pt>
                      <c:pt idx="276">
                        <c:v>4</c:v>
                      </c:pt>
                      <c:pt idx="277">
                        <c:v>2</c:v>
                      </c:pt>
                      <c:pt idx="278">
                        <c:v>4</c:v>
                      </c:pt>
                      <c:pt idx="279">
                        <c:v>2</c:v>
                      </c:pt>
                      <c:pt idx="280">
                        <c:v>6</c:v>
                      </c:pt>
                      <c:pt idx="281">
                        <c:v>2</c:v>
                      </c:pt>
                      <c:pt idx="282">
                        <c:v>3</c:v>
                      </c:pt>
                      <c:pt idx="283">
                        <c:v>1</c:v>
                      </c:pt>
                      <c:pt idx="284">
                        <c:v>3</c:v>
                      </c:pt>
                      <c:pt idx="285">
                        <c:v>7</c:v>
                      </c:pt>
                      <c:pt idx="286">
                        <c:v>2</c:v>
                      </c:pt>
                      <c:pt idx="287">
                        <c:v>4</c:v>
                      </c:pt>
                      <c:pt idx="288">
                        <c:v>3</c:v>
                      </c:pt>
                      <c:pt idx="289">
                        <c:v>8</c:v>
                      </c:pt>
                      <c:pt idx="290">
                        <c:v>6</c:v>
                      </c:pt>
                      <c:pt idx="291">
                        <c:v>10</c:v>
                      </c:pt>
                      <c:pt idx="292">
                        <c:v>2</c:v>
                      </c:pt>
                      <c:pt idx="293">
                        <c:v>7</c:v>
                      </c:pt>
                      <c:pt idx="294">
                        <c:v>5</c:v>
                      </c:pt>
                      <c:pt idx="295">
                        <c:v>11</c:v>
                      </c:pt>
                      <c:pt idx="296">
                        <c:v>3</c:v>
                      </c:pt>
                      <c:pt idx="297">
                        <c:v>1</c:v>
                      </c:pt>
                      <c:pt idx="298">
                        <c:v>5</c:v>
                      </c:pt>
                      <c:pt idx="299">
                        <c:v>5</c:v>
                      </c:pt>
                      <c:pt idx="300">
                        <c:v>2</c:v>
                      </c:pt>
                      <c:pt idx="301">
                        <c:v>2</c:v>
                      </c:pt>
                      <c:pt idx="302">
                        <c:v>5</c:v>
                      </c:pt>
                      <c:pt idx="303">
                        <c:v>2</c:v>
                      </c:pt>
                      <c:pt idx="304">
                        <c:v>2</c:v>
                      </c:pt>
                      <c:pt idx="305">
                        <c:v>5</c:v>
                      </c:pt>
                      <c:pt idx="306">
                        <c:v>8</c:v>
                      </c:pt>
                      <c:pt idx="307">
                        <c:v>1</c:v>
                      </c:pt>
                      <c:pt idx="308">
                        <c:v>1</c:v>
                      </c:pt>
                      <c:pt idx="309">
                        <c:v>4</c:v>
                      </c:pt>
                      <c:pt idx="310">
                        <c:v>4</c:v>
                      </c:pt>
                      <c:pt idx="311">
                        <c:v>10</c:v>
                      </c:pt>
                      <c:pt idx="312">
                        <c:v>1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0-1B3D-4EC0-A8D6-5E64F831BF17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1</c15:sqref>
                        </c15:formulaRef>
                      </c:ext>
                    </c:extLst>
                    <c:strCache>
                      <c:ptCount val="1"/>
                      <c:pt idx="0">
                        <c:v>Week係数</c:v>
                      </c:pt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2:$D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6.5495885664631377</c:v>
                      </c:pt>
                      <c:pt idx="1">
                        <c:v>97.294654457696282</c:v>
                      </c:pt>
                      <c:pt idx="2">
                        <c:v>169.20301511681444</c:v>
                      </c:pt>
                      <c:pt idx="3">
                        <c:v>301.45690775225728</c:v>
                      </c:pt>
                      <c:pt idx="4">
                        <c:v>262.03193507804224</c:v>
                      </c:pt>
                      <c:pt idx="5">
                        <c:v>227.47014786857261</c:v>
                      </c:pt>
                      <c:pt idx="6">
                        <c:v>166.93484089173296</c:v>
                      </c:pt>
                      <c:pt idx="7">
                        <c:v>138.75052073664625</c:v>
                      </c:pt>
                      <c:pt idx="8">
                        <c:v>145.18432015507128</c:v>
                      </c:pt>
                      <c:pt idx="9">
                        <c:v>65.075027325769639</c:v>
                      </c:pt>
                      <c:pt idx="10">
                        <c:v>74.337746705423044</c:v>
                      </c:pt>
                      <c:pt idx="11">
                        <c:v>36.228453876121549</c:v>
                      </c:pt>
                      <c:pt idx="12">
                        <c:v>44.166666666651437</c:v>
                      </c:pt>
                      <c:pt idx="13">
                        <c:v>39.464693023144832</c:v>
                      </c:pt>
                      <c:pt idx="14">
                        <c:v>7.3642269380533039</c:v>
                      </c:pt>
                      <c:pt idx="15">
                        <c:v>2.7372806203316467</c:v>
                      </c:pt>
                      <c:pt idx="16">
                        <c:v>26.32450658910825</c:v>
                      </c:pt>
                      <c:pt idx="17">
                        <c:v>-2.302439728613332</c:v>
                      </c:pt>
                      <c:pt idx="18">
                        <c:v>-14.622532945631676</c:v>
                      </c:pt>
                      <c:pt idx="19">
                        <c:v>-6.8112664728233918</c:v>
                      </c:pt>
                      <c:pt idx="20">
                        <c:v>0</c:v>
                      </c:pt>
                      <c:pt idx="21">
                        <c:v>1.1534265503365921</c:v>
                      </c:pt>
                      <c:pt idx="22">
                        <c:v>8.6313596898115428</c:v>
                      </c:pt>
                      <c:pt idx="23">
                        <c:v>-0.84657344966338188</c:v>
                      </c:pt>
                      <c:pt idx="24">
                        <c:v>-12.986759883700044</c:v>
                      </c:pt>
                      <c:pt idx="25">
                        <c:v>15.442626162619842</c:v>
                      </c:pt>
                      <c:pt idx="26">
                        <c:v>-6.1710800387867719</c:v>
                      </c:pt>
                      <c:pt idx="27">
                        <c:v>-29.447039534755014</c:v>
                      </c:pt>
                      <c:pt idx="28">
                        <c:v>-42.416145930019916</c:v>
                      </c:pt>
                      <c:pt idx="29">
                        <c:v>-15.31567984492839</c:v>
                      </c:pt>
                      <c:pt idx="30">
                        <c:v>-24.79361298440336</c:v>
                      </c:pt>
                      <c:pt idx="31">
                        <c:v>-6.3377467054534256</c:v>
                      </c:pt>
                      <c:pt idx="32">
                        <c:v>-31.442626162649994</c:v>
                      </c:pt>
                      <c:pt idx="33">
                        <c:v>-8.1666666666817527</c:v>
                      </c:pt>
                      <c:pt idx="34">
                        <c:v>-15.315679844928381</c:v>
                      </c:pt>
                      <c:pt idx="35">
                        <c:v>-20.96910639528004</c:v>
                      </c:pt>
                      <c:pt idx="36">
                        <c:v>-0.18432015510174257</c:v>
                      </c:pt>
                      <c:pt idx="37">
                        <c:v>-22.464693023175016</c:v>
                      </c:pt>
                      <c:pt idx="38">
                        <c:v>-24.293612984403357</c:v>
                      </c:pt>
                      <c:pt idx="39">
                        <c:v>-5.3377467054534176</c:v>
                      </c:pt>
                      <c:pt idx="40">
                        <c:v>-4.8377467054533998</c:v>
                      </c:pt>
                      <c:pt idx="41">
                        <c:v>-7.1666666666817411</c:v>
                      </c:pt>
                      <c:pt idx="42">
                        <c:v>7.4646930231449051</c:v>
                      </c:pt>
                      <c:pt idx="43">
                        <c:v>4.1401864340215706</c:v>
                      </c:pt>
                      <c:pt idx="44">
                        <c:v>-9.8245065891383376</c:v>
                      </c:pt>
                      <c:pt idx="45">
                        <c:v>-16.135773061946619</c:v>
                      </c:pt>
                      <c:pt idx="46">
                        <c:v>-0.33333333334836202</c:v>
                      </c:pt>
                      <c:pt idx="47">
                        <c:v>0.1666666666516104</c:v>
                      </c:pt>
                      <c:pt idx="48">
                        <c:v>6.3333333333183326</c:v>
                      </c:pt>
                      <c:pt idx="49">
                        <c:v>8.0220668605099998</c:v>
                      </c:pt>
                      <c:pt idx="50">
                        <c:v>32.061787209454913</c:v>
                      </c:pt>
                      <c:pt idx="51">
                        <c:v>59.610334302609793</c:v>
                      </c:pt>
                      <c:pt idx="52">
                        <c:v>6.5495885664631377</c:v>
                      </c:pt>
                      <c:pt idx="53">
                        <c:v>97.294654457696282</c:v>
                      </c:pt>
                      <c:pt idx="54">
                        <c:v>169.20301511681444</c:v>
                      </c:pt>
                      <c:pt idx="55">
                        <c:v>301.45690775225728</c:v>
                      </c:pt>
                      <c:pt idx="56">
                        <c:v>262.03193507804224</c:v>
                      </c:pt>
                      <c:pt idx="57">
                        <c:v>227.47014786857261</c:v>
                      </c:pt>
                      <c:pt idx="58">
                        <c:v>166.93484089173296</c:v>
                      </c:pt>
                      <c:pt idx="59">
                        <c:v>138.75052073664625</c:v>
                      </c:pt>
                      <c:pt idx="60">
                        <c:v>145.18432015507128</c:v>
                      </c:pt>
                      <c:pt idx="61">
                        <c:v>65.075027325769639</c:v>
                      </c:pt>
                      <c:pt idx="62">
                        <c:v>74.337746705423044</c:v>
                      </c:pt>
                      <c:pt idx="63">
                        <c:v>36.228453876121549</c:v>
                      </c:pt>
                      <c:pt idx="64">
                        <c:v>44.166666666651437</c:v>
                      </c:pt>
                      <c:pt idx="65">
                        <c:v>39.464693023144832</c:v>
                      </c:pt>
                      <c:pt idx="66">
                        <c:v>7.3642269380533039</c:v>
                      </c:pt>
                      <c:pt idx="67">
                        <c:v>2.7372806203316467</c:v>
                      </c:pt>
                      <c:pt idx="68">
                        <c:v>26.32450658910825</c:v>
                      </c:pt>
                      <c:pt idx="69">
                        <c:v>-2.302439728613332</c:v>
                      </c:pt>
                      <c:pt idx="70">
                        <c:v>-14.622532945631676</c:v>
                      </c:pt>
                      <c:pt idx="71">
                        <c:v>-6.8112664728233918</c:v>
                      </c:pt>
                      <c:pt idx="72">
                        <c:v>0</c:v>
                      </c:pt>
                      <c:pt idx="73">
                        <c:v>1.1534265503365921</c:v>
                      </c:pt>
                      <c:pt idx="74">
                        <c:v>8.6313596898115428</c:v>
                      </c:pt>
                      <c:pt idx="75">
                        <c:v>-0.84657344966338188</c:v>
                      </c:pt>
                      <c:pt idx="76">
                        <c:v>-12.986759883700044</c:v>
                      </c:pt>
                      <c:pt idx="77">
                        <c:v>15.442626162619842</c:v>
                      </c:pt>
                      <c:pt idx="78">
                        <c:v>-6.1710800387867719</c:v>
                      </c:pt>
                      <c:pt idx="79">
                        <c:v>-29.447039534755014</c:v>
                      </c:pt>
                      <c:pt idx="80">
                        <c:v>-42.416145930019916</c:v>
                      </c:pt>
                      <c:pt idx="81">
                        <c:v>-15.31567984492839</c:v>
                      </c:pt>
                      <c:pt idx="82">
                        <c:v>-24.79361298440336</c:v>
                      </c:pt>
                      <c:pt idx="83">
                        <c:v>-6.3377467054534256</c:v>
                      </c:pt>
                      <c:pt idx="84">
                        <c:v>-31.442626162649994</c:v>
                      </c:pt>
                      <c:pt idx="85">
                        <c:v>-8.1666666666817527</c:v>
                      </c:pt>
                      <c:pt idx="86">
                        <c:v>-15.315679844928381</c:v>
                      </c:pt>
                      <c:pt idx="87">
                        <c:v>-20.96910639528004</c:v>
                      </c:pt>
                      <c:pt idx="88">
                        <c:v>-0.18432015510174257</c:v>
                      </c:pt>
                      <c:pt idx="89">
                        <c:v>-22.464693023175016</c:v>
                      </c:pt>
                      <c:pt idx="90">
                        <c:v>-24.293612984403357</c:v>
                      </c:pt>
                      <c:pt idx="91">
                        <c:v>-5.3377467054534176</c:v>
                      </c:pt>
                      <c:pt idx="92">
                        <c:v>-4.8377467054533998</c:v>
                      </c:pt>
                      <c:pt idx="93">
                        <c:v>-7.1666666666817411</c:v>
                      </c:pt>
                      <c:pt idx="94">
                        <c:v>7.4646930231449051</c:v>
                      </c:pt>
                      <c:pt idx="95">
                        <c:v>4.1401864340215706</c:v>
                      </c:pt>
                      <c:pt idx="96">
                        <c:v>-9.8245065891383376</c:v>
                      </c:pt>
                      <c:pt idx="97">
                        <c:v>-16.135773061946619</c:v>
                      </c:pt>
                      <c:pt idx="98">
                        <c:v>-0.33333333334836202</c:v>
                      </c:pt>
                      <c:pt idx="99">
                        <c:v>0.1666666666516104</c:v>
                      </c:pt>
                      <c:pt idx="100">
                        <c:v>6.3333333333183326</c:v>
                      </c:pt>
                      <c:pt idx="101">
                        <c:v>8.0220668605099998</c:v>
                      </c:pt>
                      <c:pt idx="102">
                        <c:v>32.061787209454913</c:v>
                      </c:pt>
                      <c:pt idx="103">
                        <c:v>59.610334302609793</c:v>
                      </c:pt>
                      <c:pt idx="104">
                        <c:v>6.5495885664631377</c:v>
                      </c:pt>
                      <c:pt idx="105">
                        <c:v>97.294654457696282</c:v>
                      </c:pt>
                      <c:pt idx="106">
                        <c:v>169.20301511681444</c:v>
                      </c:pt>
                      <c:pt idx="107">
                        <c:v>301.45690775225728</c:v>
                      </c:pt>
                      <c:pt idx="108">
                        <c:v>262.03193507804224</c:v>
                      </c:pt>
                      <c:pt idx="109">
                        <c:v>227.47014786857261</c:v>
                      </c:pt>
                      <c:pt idx="110">
                        <c:v>166.93484089173296</c:v>
                      </c:pt>
                      <c:pt idx="111">
                        <c:v>138.75052073664625</c:v>
                      </c:pt>
                      <c:pt idx="112">
                        <c:v>145.18432015507128</c:v>
                      </c:pt>
                      <c:pt idx="113">
                        <c:v>65.075027325769639</c:v>
                      </c:pt>
                      <c:pt idx="114">
                        <c:v>74.337746705423044</c:v>
                      </c:pt>
                      <c:pt idx="115">
                        <c:v>36.228453876121549</c:v>
                      </c:pt>
                      <c:pt idx="116">
                        <c:v>44.166666666651437</c:v>
                      </c:pt>
                      <c:pt idx="117">
                        <c:v>39.464693023144832</c:v>
                      </c:pt>
                      <c:pt idx="118">
                        <c:v>7.3642269380533039</c:v>
                      </c:pt>
                      <c:pt idx="119">
                        <c:v>2.7372806203316467</c:v>
                      </c:pt>
                      <c:pt idx="120">
                        <c:v>26.32450658910825</c:v>
                      </c:pt>
                      <c:pt idx="121">
                        <c:v>-2.302439728613332</c:v>
                      </c:pt>
                      <c:pt idx="122">
                        <c:v>-14.622532945631676</c:v>
                      </c:pt>
                      <c:pt idx="123">
                        <c:v>-6.8112664728233918</c:v>
                      </c:pt>
                      <c:pt idx="124">
                        <c:v>0</c:v>
                      </c:pt>
                      <c:pt idx="125">
                        <c:v>1.1534265503365921</c:v>
                      </c:pt>
                      <c:pt idx="126">
                        <c:v>8.6313596898115428</c:v>
                      </c:pt>
                      <c:pt idx="127">
                        <c:v>-0.84657344966338188</c:v>
                      </c:pt>
                      <c:pt idx="128">
                        <c:v>-12.986759883700044</c:v>
                      </c:pt>
                      <c:pt idx="129">
                        <c:v>15.442626162619842</c:v>
                      </c:pt>
                      <c:pt idx="130">
                        <c:v>-6.1710800387867719</c:v>
                      </c:pt>
                      <c:pt idx="131">
                        <c:v>-29.447039534755014</c:v>
                      </c:pt>
                      <c:pt idx="132">
                        <c:v>-42.416145930019916</c:v>
                      </c:pt>
                      <c:pt idx="133">
                        <c:v>-15.31567984492839</c:v>
                      </c:pt>
                      <c:pt idx="134">
                        <c:v>-24.79361298440336</c:v>
                      </c:pt>
                      <c:pt idx="135">
                        <c:v>-6.3377467054534256</c:v>
                      </c:pt>
                      <c:pt idx="136">
                        <c:v>-31.442626162649994</c:v>
                      </c:pt>
                      <c:pt idx="137">
                        <c:v>-8.1666666666817527</c:v>
                      </c:pt>
                      <c:pt idx="138">
                        <c:v>-15.315679844928381</c:v>
                      </c:pt>
                      <c:pt idx="139">
                        <c:v>-20.96910639528004</c:v>
                      </c:pt>
                      <c:pt idx="140">
                        <c:v>-0.18432015510174257</c:v>
                      </c:pt>
                      <c:pt idx="141">
                        <c:v>-22.464693023175016</c:v>
                      </c:pt>
                      <c:pt idx="142">
                        <c:v>-24.293612984403357</c:v>
                      </c:pt>
                      <c:pt idx="143">
                        <c:v>-5.3377467054534176</c:v>
                      </c:pt>
                      <c:pt idx="144">
                        <c:v>-4.8377467054533998</c:v>
                      </c:pt>
                      <c:pt idx="145">
                        <c:v>-7.1666666666817411</c:v>
                      </c:pt>
                      <c:pt idx="146">
                        <c:v>7.4646930231449051</c:v>
                      </c:pt>
                      <c:pt idx="147">
                        <c:v>4.1401864340215706</c:v>
                      </c:pt>
                      <c:pt idx="148">
                        <c:v>-9.8245065891383376</c:v>
                      </c:pt>
                      <c:pt idx="149">
                        <c:v>-16.135773061946619</c:v>
                      </c:pt>
                      <c:pt idx="150">
                        <c:v>-0.33333333334836202</c:v>
                      </c:pt>
                      <c:pt idx="151">
                        <c:v>0.1666666666516104</c:v>
                      </c:pt>
                      <c:pt idx="152">
                        <c:v>6.3333333333183326</c:v>
                      </c:pt>
                      <c:pt idx="153">
                        <c:v>8.0220668605099998</c:v>
                      </c:pt>
                      <c:pt idx="154">
                        <c:v>32.061787209454913</c:v>
                      </c:pt>
                      <c:pt idx="155">
                        <c:v>59.610334302609793</c:v>
                      </c:pt>
                      <c:pt idx="156">
                        <c:v>6.5495885664631377</c:v>
                      </c:pt>
                      <c:pt idx="157">
                        <c:v>97.294654457696282</c:v>
                      </c:pt>
                      <c:pt idx="158">
                        <c:v>169.20301511681444</c:v>
                      </c:pt>
                      <c:pt idx="159">
                        <c:v>301.45690775225728</c:v>
                      </c:pt>
                      <c:pt idx="160">
                        <c:v>262.03193507804224</c:v>
                      </c:pt>
                      <c:pt idx="161">
                        <c:v>227.47014786857261</c:v>
                      </c:pt>
                      <c:pt idx="162">
                        <c:v>166.93484089173296</c:v>
                      </c:pt>
                      <c:pt idx="163">
                        <c:v>138.75052073664625</c:v>
                      </c:pt>
                      <c:pt idx="164">
                        <c:v>145.18432015507128</c:v>
                      </c:pt>
                      <c:pt idx="165">
                        <c:v>65.075027325769639</c:v>
                      </c:pt>
                      <c:pt idx="166">
                        <c:v>74.337746705423044</c:v>
                      </c:pt>
                      <c:pt idx="167">
                        <c:v>36.228453876121549</c:v>
                      </c:pt>
                      <c:pt idx="168">
                        <c:v>44.166666666651437</c:v>
                      </c:pt>
                      <c:pt idx="169">
                        <c:v>39.464693023144832</c:v>
                      </c:pt>
                      <c:pt idx="170">
                        <c:v>7.3642269380533039</c:v>
                      </c:pt>
                      <c:pt idx="171">
                        <c:v>2.7372806203316467</c:v>
                      </c:pt>
                      <c:pt idx="172">
                        <c:v>26.32450658910825</c:v>
                      </c:pt>
                      <c:pt idx="173">
                        <c:v>-2.302439728613332</c:v>
                      </c:pt>
                      <c:pt idx="174">
                        <c:v>-14.622532945631676</c:v>
                      </c:pt>
                      <c:pt idx="175">
                        <c:v>-6.8112664728233918</c:v>
                      </c:pt>
                      <c:pt idx="176">
                        <c:v>0</c:v>
                      </c:pt>
                      <c:pt idx="177">
                        <c:v>1.1534265503365921</c:v>
                      </c:pt>
                      <c:pt idx="178">
                        <c:v>8.6313596898115428</c:v>
                      </c:pt>
                      <c:pt idx="179">
                        <c:v>-0.84657344966338188</c:v>
                      </c:pt>
                      <c:pt idx="180">
                        <c:v>-12.986759883700044</c:v>
                      </c:pt>
                      <c:pt idx="181">
                        <c:v>15.442626162619842</c:v>
                      </c:pt>
                      <c:pt idx="182">
                        <c:v>-6.1710800387867719</c:v>
                      </c:pt>
                      <c:pt idx="183">
                        <c:v>-29.447039534755014</c:v>
                      </c:pt>
                      <c:pt idx="184">
                        <c:v>-42.416145930019916</c:v>
                      </c:pt>
                      <c:pt idx="185">
                        <c:v>-15.31567984492839</c:v>
                      </c:pt>
                      <c:pt idx="186">
                        <c:v>-24.79361298440336</c:v>
                      </c:pt>
                      <c:pt idx="187">
                        <c:v>-6.3377467054534256</c:v>
                      </c:pt>
                      <c:pt idx="188">
                        <c:v>-31.442626162649994</c:v>
                      </c:pt>
                      <c:pt idx="189">
                        <c:v>-8.1666666666817527</c:v>
                      </c:pt>
                      <c:pt idx="190">
                        <c:v>-15.315679844928381</c:v>
                      </c:pt>
                      <c:pt idx="191">
                        <c:v>-20.96910639528004</c:v>
                      </c:pt>
                      <c:pt idx="192">
                        <c:v>-0.18432015510174257</c:v>
                      </c:pt>
                      <c:pt idx="193">
                        <c:v>-22.464693023175016</c:v>
                      </c:pt>
                      <c:pt idx="194">
                        <c:v>-24.293612984403357</c:v>
                      </c:pt>
                      <c:pt idx="195">
                        <c:v>-5.3377467054534176</c:v>
                      </c:pt>
                      <c:pt idx="196">
                        <c:v>-4.8377467054533998</c:v>
                      </c:pt>
                      <c:pt idx="197">
                        <c:v>-7.1666666666817411</c:v>
                      </c:pt>
                      <c:pt idx="198">
                        <c:v>7.4646930231449051</c:v>
                      </c:pt>
                      <c:pt idx="199">
                        <c:v>4.1401864340215706</c:v>
                      </c:pt>
                      <c:pt idx="200">
                        <c:v>-9.8245065891383376</c:v>
                      </c:pt>
                      <c:pt idx="201">
                        <c:v>-16.135773061946619</c:v>
                      </c:pt>
                      <c:pt idx="202">
                        <c:v>-0.33333333334836202</c:v>
                      </c:pt>
                      <c:pt idx="203">
                        <c:v>0.1666666666516104</c:v>
                      </c:pt>
                      <c:pt idx="204">
                        <c:v>6.3333333333183326</c:v>
                      </c:pt>
                      <c:pt idx="205">
                        <c:v>8.0220668605099998</c:v>
                      </c:pt>
                      <c:pt idx="206">
                        <c:v>32.061787209454913</c:v>
                      </c:pt>
                      <c:pt idx="207">
                        <c:v>59.610334302609793</c:v>
                      </c:pt>
                      <c:pt idx="208">
                        <c:v>-67.805811627394831</c:v>
                      </c:pt>
                      <c:pt idx="209">
                        <c:v>6.5495885664631377</c:v>
                      </c:pt>
                      <c:pt idx="210">
                        <c:v>97.294654457696282</c:v>
                      </c:pt>
                      <c:pt idx="211">
                        <c:v>169.20301511681444</c:v>
                      </c:pt>
                      <c:pt idx="212">
                        <c:v>301.45690775225728</c:v>
                      </c:pt>
                      <c:pt idx="213">
                        <c:v>262.03193507804224</c:v>
                      </c:pt>
                      <c:pt idx="214">
                        <c:v>227.47014786857261</c:v>
                      </c:pt>
                      <c:pt idx="215">
                        <c:v>166.93484089173296</c:v>
                      </c:pt>
                      <c:pt idx="216">
                        <c:v>138.75052073664625</c:v>
                      </c:pt>
                      <c:pt idx="217">
                        <c:v>145.18432015507128</c:v>
                      </c:pt>
                      <c:pt idx="218">
                        <c:v>65.075027325769639</c:v>
                      </c:pt>
                      <c:pt idx="219">
                        <c:v>74.337746705423044</c:v>
                      </c:pt>
                      <c:pt idx="220">
                        <c:v>36.228453876121549</c:v>
                      </c:pt>
                      <c:pt idx="221">
                        <c:v>44.166666666651437</c:v>
                      </c:pt>
                      <c:pt idx="222">
                        <c:v>39.464693023144832</c:v>
                      </c:pt>
                      <c:pt idx="223">
                        <c:v>7.3642269380533039</c:v>
                      </c:pt>
                      <c:pt idx="224">
                        <c:v>2.7372806203316467</c:v>
                      </c:pt>
                      <c:pt idx="225">
                        <c:v>26.32450658910825</c:v>
                      </c:pt>
                      <c:pt idx="226">
                        <c:v>-2.302439728613332</c:v>
                      </c:pt>
                      <c:pt idx="227">
                        <c:v>-14.622532945631676</c:v>
                      </c:pt>
                      <c:pt idx="228">
                        <c:v>-6.8112664728233918</c:v>
                      </c:pt>
                      <c:pt idx="229">
                        <c:v>0</c:v>
                      </c:pt>
                      <c:pt idx="230">
                        <c:v>1.1534265503365921</c:v>
                      </c:pt>
                      <c:pt idx="231">
                        <c:v>8.6313596898115428</c:v>
                      </c:pt>
                      <c:pt idx="232">
                        <c:v>-0.84657344966338188</c:v>
                      </c:pt>
                      <c:pt idx="233">
                        <c:v>-12.986759883700044</c:v>
                      </c:pt>
                      <c:pt idx="234">
                        <c:v>15.442626162619842</c:v>
                      </c:pt>
                      <c:pt idx="235">
                        <c:v>-6.1710800387867719</c:v>
                      </c:pt>
                      <c:pt idx="236">
                        <c:v>-29.447039534755014</c:v>
                      </c:pt>
                      <c:pt idx="237">
                        <c:v>-42.416145930019916</c:v>
                      </c:pt>
                      <c:pt idx="238">
                        <c:v>-15.31567984492839</c:v>
                      </c:pt>
                      <c:pt idx="239">
                        <c:v>-24.79361298440336</c:v>
                      </c:pt>
                      <c:pt idx="240">
                        <c:v>-6.3377467054534256</c:v>
                      </c:pt>
                      <c:pt idx="241">
                        <c:v>-31.442626162649994</c:v>
                      </c:pt>
                      <c:pt idx="242">
                        <c:v>-8.1666666666817527</c:v>
                      </c:pt>
                      <c:pt idx="243">
                        <c:v>-15.315679844928381</c:v>
                      </c:pt>
                      <c:pt idx="244">
                        <c:v>-20.96910639528004</c:v>
                      </c:pt>
                      <c:pt idx="245">
                        <c:v>-0.18432015510174257</c:v>
                      </c:pt>
                      <c:pt idx="246">
                        <c:v>-22.464693023175016</c:v>
                      </c:pt>
                      <c:pt idx="247">
                        <c:v>-24.293612984403357</c:v>
                      </c:pt>
                      <c:pt idx="248">
                        <c:v>-5.3377467054534176</c:v>
                      </c:pt>
                      <c:pt idx="249">
                        <c:v>-4.8377467054533998</c:v>
                      </c:pt>
                      <c:pt idx="250">
                        <c:v>-7.1666666666817411</c:v>
                      </c:pt>
                      <c:pt idx="251">
                        <c:v>7.4646930231449051</c:v>
                      </c:pt>
                      <c:pt idx="252">
                        <c:v>4.1401864340215706</c:v>
                      </c:pt>
                      <c:pt idx="253">
                        <c:v>-9.8245065891383376</c:v>
                      </c:pt>
                      <c:pt idx="254">
                        <c:v>-16.135773061946619</c:v>
                      </c:pt>
                      <c:pt idx="255">
                        <c:v>-0.33333333334836202</c:v>
                      </c:pt>
                      <c:pt idx="256">
                        <c:v>0.1666666666516104</c:v>
                      </c:pt>
                      <c:pt idx="257">
                        <c:v>6.3333333333183326</c:v>
                      </c:pt>
                      <c:pt idx="258">
                        <c:v>8.0220668605099998</c:v>
                      </c:pt>
                      <c:pt idx="259">
                        <c:v>32.061787209454913</c:v>
                      </c:pt>
                      <c:pt idx="260">
                        <c:v>59.610334302609793</c:v>
                      </c:pt>
                      <c:pt idx="261">
                        <c:v>6.5495885664631377</c:v>
                      </c:pt>
                      <c:pt idx="262">
                        <c:v>97.294654457696282</c:v>
                      </c:pt>
                      <c:pt idx="263">
                        <c:v>169.20301511681444</c:v>
                      </c:pt>
                      <c:pt idx="264">
                        <c:v>301.45690775225728</c:v>
                      </c:pt>
                      <c:pt idx="265">
                        <c:v>262.03193507804224</c:v>
                      </c:pt>
                      <c:pt idx="266">
                        <c:v>227.47014786857261</c:v>
                      </c:pt>
                      <c:pt idx="267">
                        <c:v>166.93484089173296</c:v>
                      </c:pt>
                      <c:pt idx="268">
                        <c:v>138.75052073664625</c:v>
                      </c:pt>
                      <c:pt idx="269">
                        <c:v>145.18432015507128</c:v>
                      </c:pt>
                      <c:pt idx="270">
                        <c:v>65.075027325769639</c:v>
                      </c:pt>
                      <c:pt idx="271">
                        <c:v>74.337746705423044</c:v>
                      </c:pt>
                      <c:pt idx="272">
                        <c:v>36.228453876121549</c:v>
                      </c:pt>
                      <c:pt idx="273">
                        <c:v>44.166666666651437</c:v>
                      </c:pt>
                      <c:pt idx="274">
                        <c:v>39.464693023144832</c:v>
                      </c:pt>
                      <c:pt idx="275">
                        <c:v>7.3642269380533039</c:v>
                      </c:pt>
                      <c:pt idx="276">
                        <c:v>2.7372806203316467</c:v>
                      </c:pt>
                      <c:pt idx="277">
                        <c:v>26.32450658910825</c:v>
                      </c:pt>
                      <c:pt idx="278">
                        <c:v>-2.302439728613332</c:v>
                      </c:pt>
                      <c:pt idx="279">
                        <c:v>-14.622532945631676</c:v>
                      </c:pt>
                      <c:pt idx="280">
                        <c:v>-6.8112664728233918</c:v>
                      </c:pt>
                      <c:pt idx="281">
                        <c:v>0</c:v>
                      </c:pt>
                      <c:pt idx="282">
                        <c:v>1.1534265503365921</c:v>
                      </c:pt>
                      <c:pt idx="283">
                        <c:v>8.6313596898115428</c:v>
                      </c:pt>
                      <c:pt idx="284">
                        <c:v>-0.84657344966338188</c:v>
                      </c:pt>
                      <c:pt idx="285">
                        <c:v>-12.986759883700044</c:v>
                      </c:pt>
                      <c:pt idx="286">
                        <c:v>15.442626162619842</c:v>
                      </c:pt>
                      <c:pt idx="287">
                        <c:v>-6.1710800387867719</c:v>
                      </c:pt>
                      <c:pt idx="288">
                        <c:v>-29.447039534755014</c:v>
                      </c:pt>
                      <c:pt idx="289">
                        <c:v>-42.416145930019916</c:v>
                      </c:pt>
                      <c:pt idx="290">
                        <c:v>-15.31567984492839</c:v>
                      </c:pt>
                      <c:pt idx="291">
                        <c:v>-24.79361298440336</c:v>
                      </c:pt>
                      <c:pt idx="292">
                        <c:v>-6.3377467054534256</c:v>
                      </c:pt>
                      <c:pt idx="293">
                        <c:v>-31.442626162649994</c:v>
                      </c:pt>
                      <c:pt idx="294">
                        <c:v>-8.1666666666817527</c:v>
                      </c:pt>
                      <c:pt idx="295">
                        <c:v>-15.315679844928381</c:v>
                      </c:pt>
                      <c:pt idx="296">
                        <c:v>-20.96910639528004</c:v>
                      </c:pt>
                      <c:pt idx="297">
                        <c:v>-0.18432015510174257</c:v>
                      </c:pt>
                      <c:pt idx="298">
                        <c:v>-22.464693023175016</c:v>
                      </c:pt>
                      <c:pt idx="299">
                        <c:v>-24.293612984403357</c:v>
                      </c:pt>
                      <c:pt idx="300">
                        <c:v>-5.3377467054534176</c:v>
                      </c:pt>
                      <c:pt idx="301">
                        <c:v>-4.8377467054533998</c:v>
                      </c:pt>
                      <c:pt idx="302">
                        <c:v>-7.1666666666817411</c:v>
                      </c:pt>
                      <c:pt idx="303">
                        <c:v>7.4646930231449051</c:v>
                      </c:pt>
                      <c:pt idx="304">
                        <c:v>4.1401864340215706</c:v>
                      </c:pt>
                      <c:pt idx="305">
                        <c:v>-9.8245065891383376</c:v>
                      </c:pt>
                      <c:pt idx="306">
                        <c:v>-16.135773061946619</c:v>
                      </c:pt>
                      <c:pt idx="307">
                        <c:v>-0.33333333334836202</c:v>
                      </c:pt>
                      <c:pt idx="308">
                        <c:v>0.1666666666516104</c:v>
                      </c:pt>
                      <c:pt idx="309">
                        <c:v>6.3333333333183326</c:v>
                      </c:pt>
                      <c:pt idx="310">
                        <c:v>8.0220668605099998</c:v>
                      </c:pt>
                      <c:pt idx="311">
                        <c:v>32.061787209454913</c:v>
                      </c:pt>
                      <c:pt idx="312">
                        <c:v>59.610334302609793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2-1B3D-4EC0-A8D6-5E64F831BF17}"/>
                  </c:ext>
                </c:extLst>
              </c15:ser>
            </c15:filteredLineSeries>
          </c:ext>
        </c:extLst>
      </c:lineChart>
      <c:catAx>
        <c:axId val="1627113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6116352"/>
        <c:crosses val="autoZero"/>
        <c:auto val="1"/>
        <c:lblAlgn val="ctr"/>
        <c:lblOffset val="100"/>
        <c:noMultiLvlLbl val="0"/>
      </c:catAx>
      <c:valAx>
        <c:axId val="1626116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 of influenza case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7113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405946173085094"/>
          <c:y val="0.87306911636045492"/>
          <c:w val="0.3543453786150203"/>
          <c:h val="0.117671624380285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701</cdr:x>
      <cdr:y>0.01822</cdr:y>
    </cdr:from>
    <cdr:to>
      <cdr:x>0.9879</cdr:x>
      <cdr:y>0.07407</cdr:y>
    </cdr:to>
    <cdr:sp macro="" textlink="">
      <cdr:nvSpPr>
        <cdr:cNvPr id="2" name="タイトル 2"/>
        <cdr:cNvSpPr>
          <a:spLocks xmlns:a="http://schemas.openxmlformats.org/drawingml/2006/main" noGrp="1"/>
        </cdr:cNvSpPr>
      </cdr:nvSpPr>
      <cdr:spPr>
        <a:xfrm xmlns:a="http://schemas.openxmlformats.org/drawingml/2006/main">
          <a:off x="889000" y="124980"/>
          <a:ext cx="10515600" cy="3830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horz" lIns="91440" tIns="45720" rIns="91440" bIns="45720" rtlCol="0" anchor="ctr">
          <a:normAutofit fontScale="90000"/>
        </a:bodyPr>
        <a:lstStyle xmlns:a="http://schemas.openxmlformats.org/drawingml/2006/main">
          <a:lvl1pPr algn="l" defTabSz="914400" rtl="0" eaLnBrk="1" latinLnBrk="0" hangingPunct="1">
            <a:lnSpc>
              <a:spcPct val="90000"/>
            </a:lnSpc>
            <a:spcBef>
              <a:spcPct val="0"/>
            </a:spcBef>
            <a:buNone/>
            <a:defRPr kumimoji="1" sz="4400" kern="1200">
              <a:solidFill>
                <a:schemeClr val="tx1"/>
              </a:solidFill>
              <a:latin typeface="+mj-lt"/>
              <a:ea typeface="+mj-ea"/>
              <a:cs typeface="+mj-cs"/>
            </a:defRPr>
          </a:lvl1pPr>
        </a:lstStyle>
        <a:p xmlns:a="http://schemas.openxmlformats.org/drawingml/2006/main">
          <a:r>
            <a:rPr kumimoji="1" lang="en-US" altLang="ja-JP" smtClean="0">
              <a:latin typeface="Times New Roman" panose="02020603050405020304" pitchFamily="18" charset="0"/>
              <a:cs typeface="Times New Roman" panose="02020603050405020304" pitchFamily="18" charset="0"/>
            </a:rPr>
            <a:t>Sample Figure </a:t>
          </a:r>
          <a:r>
            <a: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endParaRPr kumimoji="1" lang="ja-JP" altLang="en-US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172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780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173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463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466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264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7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851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730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184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099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761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/>
          <p:cNvGraphicFramePr/>
          <p:nvPr>
            <p:extLst>
              <p:ext uri="{D42A27DB-BD31-4B8C-83A1-F6EECF244321}">
                <p14:modId xmlns:p14="http://schemas.microsoft.com/office/powerpoint/2010/main" val="4054514815"/>
              </p:ext>
            </p:extLst>
          </p:nvPr>
        </p:nvGraphicFramePr>
        <p:xfrm>
          <a:off x="333375" y="0"/>
          <a:ext cx="11544299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35122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0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ayama Yusuke</dc:creator>
  <cp:lastModifiedBy>Katayama Yusuke</cp:lastModifiedBy>
  <cp:revision>6</cp:revision>
  <dcterms:created xsi:type="dcterms:W3CDTF">2020-03-26T05:47:16Z</dcterms:created>
  <dcterms:modified xsi:type="dcterms:W3CDTF">2020-03-31T06:43:09Z</dcterms:modified>
</cp:coreProperties>
</file>